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20.jpeg" ContentType="image/jpeg"/>
  <Override PartName="/ppt/media/image7.png" ContentType="image/png"/>
  <Override PartName="/ppt/media/image11.png" ContentType="image/png"/>
  <Override PartName="/ppt/media/image19.jpeg" ContentType="image/jpeg"/>
  <Override PartName="/ppt/media/image6.png" ContentType="image/png"/>
  <Override PartName="/ppt/media/image10.png" ContentType="image/png"/>
  <Override PartName="/ppt/media/image5.png" ContentType="image/png"/>
  <Override PartName="/ppt/media/image4.png" ContentType="image/png"/>
  <Override PartName="/ppt/media/image27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8.png" ContentType="image/png"/>
  <Override PartName="/ppt/media/image15.jpeg" ContentType="image/jpeg"/>
  <Override PartName="/ppt/media/image17.png" ContentType="image/png"/>
  <Override PartName="/ppt/media/image16.jpeg" ContentType="image/jpeg"/>
  <Override PartName="/ppt/media/image14.png" ContentType="image/png"/>
  <Override PartName="/ppt/media/image3.png" ContentType="image/png"/>
  <Override PartName="/ppt/media/image26.png" ContentType="image/png"/>
  <Override PartName="/ppt/media/image24.png" ContentType="image/png"/>
  <Override PartName="/ppt/media/image1.png" ContentType="image/png"/>
  <Override PartName="/ppt/media/image25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</p:sldIdLst>
  <p:sldSz cx="6858000" cy="9144000"/>
  <p:notesSz cx="7275513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A35760-3661-4FE3-B619-B47EDC40B94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A71E98-BD4D-4C99-B595-BD727DDFD6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CD0941-2D76-4B0A-9D9A-6986AFD9FBD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5EBF76-9D78-48FB-BF11-77C756C19EB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6AAB74-0B36-4717-B200-272D54C38F2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F64AEC-FEF5-475D-ABE8-39532392E26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31E573-F5FB-4515-ABBD-65FD3BE0D55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1391C9-8977-4760-A705-604946ACC1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725BC1-B263-4CB9-A456-E966D6FC60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C1B1F1-9B6C-42CF-AA81-92ECE99EE4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81CA26-AFBD-46FB-A8F1-864029B9A8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A1FA27-FDB9-410A-9BC5-4EF47BA233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F9B9DE8-C2AA-45E6-B3F1-9574AD256459}" type="slidenum">
              <a:rPr b="0" lang="ja-JP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image" Target="../media/image23.png"/><Relationship Id="rId3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24.png"/><Relationship Id="rId2" Type="http://schemas.openxmlformats.org/officeDocument/2006/relationships/image" Target="../media/image25.png"/><Relationship Id="rId3" Type="http://schemas.openxmlformats.org/officeDocument/2006/relationships/image" Target="../media/image26.png"/><Relationship Id="rId4" Type="http://schemas.openxmlformats.org/officeDocument/2006/relationships/image" Target="../media/image27.png"/><Relationship Id="rId5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image" Target="../media/image9.png"/><Relationship Id="rId4" Type="http://schemas.openxmlformats.org/officeDocument/2006/relationships/image" Target="../media/image10.png"/><Relationship Id="rId5" Type="http://schemas.openxmlformats.org/officeDocument/2006/relationships/image" Target="../media/image11.png"/><Relationship Id="rId6" Type="http://schemas.openxmlformats.org/officeDocument/2006/relationships/image" Target="../media/image12.png"/><Relationship Id="rId7" Type="http://schemas.openxmlformats.org/officeDocument/2006/relationships/image" Target="../media/image13.png"/><Relationship Id="rId8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5.jpeg"/><Relationship Id="rId2" Type="http://schemas.openxmlformats.org/officeDocument/2006/relationships/image" Target="../media/image16.jpeg"/><Relationship Id="rId3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image" Target="../media/image18.png"/><Relationship Id="rId3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9.jpeg"/><Relationship Id="rId2" Type="http://schemas.openxmlformats.org/officeDocument/2006/relationships/image" Target="../media/image20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3"/>
          <p:cNvSpPr/>
          <p:nvPr/>
        </p:nvSpPr>
        <p:spPr>
          <a:xfrm>
            <a:off x="635040" y="8356680"/>
            <a:ext cx="55879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. Flowchart of the analysis for metagenomics sequences. we used paired-end and conting assembly approaches for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gcA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enumeration and phylogenetic analyses in the seawater column, respectively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テキスト ボックス 4"/>
          <p:cNvSpPr/>
          <p:nvPr/>
        </p:nvSpPr>
        <p:spPr>
          <a:xfrm>
            <a:off x="3009600" y="722160"/>
            <a:ext cx="1302480" cy="23112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etagenomic sequences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テキスト ボックス 5"/>
          <p:cNvSpPr/>
          <p:nvPr/>
        </p:nvSpPr>
        <p:spPr>
          <a:xfrm>
            <a:off x="2259000" y="1090440"/>
            <a:ext cx="2803680" cy="23112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move adapter sequences with Cutadapt (Martin, 2011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正方形/長方形 6"/>
          <p:cNvSpPr/>
          <p:nvPr/>
        </p:nvSpPr>
        <p:spPr>
          <a:xfrm>
            <a:off x="993600" y="2160720"/>
            <a:ext cx="2159280" cy="36828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Paired-end assembly with PEAR (Zhang et al., 2013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正方形/長方形 7"/>
          <p:cNvSpPr/>
          <p:nvPr/>
        </p:nvSpPr>
        <p:spPr>
          <a:xfrm>
            <a:off x="993600" y="2787480"/>
            <a:ext cx="2159280" cy="64260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Trim the low quality sequences by the FastXToolKit (http://hannonlab.cshl.edu/fastx_toolkit/) and PRINSEQ (Schmieder et al., 2011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正方形/長方形 8"/>
          <p:cNvSpPr/>
          <p:nvPr/>
        </p:nvSpPr>
        <p:spPr>
          <a:xfrm>
            <a:off x="993600" y="3716280"/>
            <a:ext cx="2159280" cy="50544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Predict  the genes in the metagenomic sequences by MetaGeneAnnotator (Noguchi et al., 2008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正方形/長方形 9"/>
          <p:cNvSpPr/>
          <p:nvPr/>
        </p:nvSpPr>
        <p:spPr>
          <a:xfrm>
            <a:off x="1573200" y="4749840"/>
            <a:ext cx="1004760" cy="119124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Detection of the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hgcA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and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hgcB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sequences in our metagenomes with the Hidden Markov model (HMM) in HMMER v3.2.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正方形/長方形 10"/>
          <p:cNvSpPr/>
          <p:nvPr/>
        </p:nvSpPr>
        <p:spPr>
          <a:xfrm>
            <a:off x="4232160" y="2160720"/>
            <a:ext cx="2087640" cy="50544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Construct the contigs with longer metagenomic reads by MEGAHIT (Li et al., 2016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正方形/長方形 11"/>
          <p:cNvSpPr/>
          <p:nvPr/>
        </p:nvSpPr>
        <p:spPr>
          <a:xfrm>
            <a:off x="4230720" y="2892600"/>
            <a:ext cx="2092320" cy="50544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Predict  the genes in the metagenomic sequences by MetaGeneAnnotator (Noguchi et al., 2008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正方形/長方形 12"/>
          <p:cNvSpPr/>
          <p:nvPr/>
        </p:nvSpPr>
        <p:spPr>
          <a:xfrm>
            <a:off x="4230720" y="3716280"/>
            <a:ext cx="2092320" cy="64260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Detection of the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hgcA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and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hgcB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sequences in our metagenomes with the Hidden Markov model (HMM) in HMMER v3.2.1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正方形/長方形 13"/>
          <p:cNvSpPr/>
          <p:nvPr/>
        </p:nvSpPr>
        <p:spPr>
          <a:xfrm>
            <a:off x="1573200" y="6257880"/>
            <a:ext cx="1004760" cy="105408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Re-check the specificity of HMMs for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hgcAB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sequences using hmmsearch (HMMER v3.2.1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正方形/長方形 14"/>
          <p:cNvSpPr/>
          <p:nvPr/>
        </p:nvSpPr>
        <p:spPr>
          <a:xfrm>
            <a:off x="4230720" y="4749840"/>
            <a:ext cx="2092320" cy="50544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To re-check the specificity of HMMs for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hgcAB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sequences using hmmsearch (HMMER v3.2.1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正方形/長方形 18"/>
          <p:cNvSpPr/>
          <p:nvPr/>
        </p:nvSpPr>
        <p:spPr>
          <a:xfrm>
            <a:off x="2712960" y="4749840"/>
            <a:ext cx="1247760" cy="173988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valuate the abundance of prokaryotic functional modules using the MAPLE ( https://maple.jamstec.go.jp/maple/maple-2.3.1; Takami et al., 2013) with the genes and module database (version 13 Jul 2018) defined by the KEGG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4" name="直線矢印コネクタ 21"/>
          <p:cNvCxnSpPr>
            <a:stCxn id="42" idx="2"/>
            <a:endCxn id="43" idx="0"/>
          </p:cNvCxnSpPr>
          <p:nvPr/>
        </p:nvCxnSpPr>
        <p:spPr>
          <a:xfrm>
            <a:off x="3660840" y="953280"/>
            <a:ext cx="360" cy="137520"/>
          </a:xfrm>
          <a:prstGeom prst="straightConnector1">
            <a:avLst/>
          </a:prstGeom>
          <a:ln w="0">
            <a:solidFill>
              <a:srgbClr val="000000"/>
            </a:solidFill>
            <a:tailEnd len="med" type="triangle" w="med"/>
          </a:ln>
        </p:spPr>
      </p:cxnSp>
      <p:cxnSp>
        <p:nvCxnSpPr>
          <p:cNvPr id="55" name="直線矢印コネクタ 25"/>
          <p:cNvCxnSpPr>
            <a:stCxn id="43" idx="2"/>
          </p:cNvCxnSpPr>
          <p:nvPr/>
        </p:nvCxnSpPr>
        <p:spPr>
          <a:xfrm flipH="1">
            <a:off x="2701440" y="1321560"/>
            <a:ext cx="959760" cy="839520"/>
          </a:xfrm>
          <a:prstGeom prst="straightConnector1">
            <a:avLst/>
          </a:prstGeom>
          <a:ln w="0">
            <a:solidFill>
              <a:srgbClr val="000000"/>
            </a:solidFill>
            <a:tailEnd len="med" type="triangle" w="med"/>
          </a:ln>
        </p:spPr>
      </p:cxnSp>
      <p:cxnSp>
        <p:nvCxnSpPr>
          <p:cNvPr id="56" name="直線矢印コネクタ 29"/>
          <p:cNvCxnSpPr/>
          <p:nvPr/>
        </p:nvCxnSpPr>
        <p:spPr>
          <a:xfrm>
            <a:off x="3660840" y="1325520"/>
            <a:ext cx="946800" cy="821520"/>
          </a:xfrm>
          <a:prstGeom prst="straightConnector1">
            <a:avLst/>
          </a:prstGeom>
          <a:ln w="0">
            <a:solidFill>
              <a:srgbClr val="000000"/>
            </a:solidFill>
            <a:tailEnd len="med" type="triangle" w="med"/>
          </a:ln>
        </p:spPr>
      </p:cxnSp>
      <p:cxnSp>
        <p:nvCxnSpPr>
          <p:cNvPr id="57" name="直線矢印コネクタ 32"/>
          <p:cNvCxnSpPr>
            <a:stCxn id="44" idx="2"/>
            <a:endCxn id="45" idx="0"/>
          </p:cNvCxnSpPr>
          <p:nvPr/>
        </p:nvCxnSpPr>
        <p:spPr>
          <a:xfrm>
            <a:off x="2073240" y="2529000"/>
            <a:ext cx="360" cy="258840"/>
          </a:xfrm>
          <a:prstGeom prst="straightConnector1">
            <a:avLst/>
          </a:prstGeom>
          <a:ln w="0">
            <a:solidFill>
              <a:srgbClr val="000000"/>
            </a:solidFill>
            <a:tailEnd len="med" type="triangle" w="med"/>
          </a:ln>
        </p:spPr>
      </p:cxnSp>
      <p:cxnSp>
        <p:nvCxnSpPr>
          <p:cNvPr id="58" name="直線矢印コネクタ 35"/>
          <p:cNvCxnSpPr>
            <a:stCxn id="45" idx="2"/>
            <a:endCxn id="46" idx="0"/>
          </p:cNvCxnSpPr>
          <p:nvPr/>
        </p:nvCxnSpPr>
        <p:spPr>
          <a:xfrm>
            <a:off x="2073240" y="3430080"/>
            <a:ext cx="360" cy="286560"/>
          </a:xfrm>
          <a:prstGeom prst="straightConnector1">
            <a:avLst/>
          </a:prstGeom>
          <a:ln w="0">
            <a:solidFill>
              <a:srgbClr val="000000"/>
            </a:solidFill>
            <a:tailEnd len="med" type="triangle" w="med"/>
          </a:ln>
        </p:spPr>
      </p:cxnSp>
      <p:cxnSp>
        <p:nvCxnSpPr>
          <p:cNvPr id="59" name="直線矢印コネクタ 45"/>
          <p:cNvCxnSpPr>
            <a:stCxn id="47" idx="2"/>
          </p:cNvCxnSpPr>
          <p:nvPr/>
        </p:nvCxnSpPr>
        <p:spPr>
          <a:xfrm>
            <a:off x="2075400" y="5941080"/>
            <a:ext cx="1800" cy="317160"/>
          </a:xfrm>
          <a:prstGeom prst="straightConnector1">
            <a:avLst/>
          </a:prstGeom>
          <a:ln w="0">
            <a:solidFill>
              <a:srgbClr val="000000"/>
            </a:solidFill>
            <a:tailEnd len="med" type="triangle" w="med"/>
          </a:ln>
        </p:spPr>
      </p:cxnSp>
      <p:cxnSp>
        <p:nvCxnSpPr>
          <p:cNvPr id="60" name="直線矢印コネクタ 48"/>
          <p:cNvCxnSpPr>
            <a:stCxn id="48" idx="2"/>
            <a:endCxn id="49" idx="0"/>
          </p:cNvCxnSpPr>
          <p:nvPr/>
        </p:nvCxnSpPr>
        <p:spPr>
          <a:xfrm>
            <a:off x="5275800" y="2666160"/>
            <a:ext cx="1440" cy="226800"/>
          </a:xfrm>
          <a:prstGeom prst="straightConnector1">
            <a:avLst/>
          </a:prstGeom>
          <a:ln w="0">
            <a:solidFill>
              <a:srgbClr val="000000"/>
            </a:solidFill>
            <a:tailEnd len="med" type="triangle" w="med"/>
          </a:ln>
        </p:spPr>
      </p:cxnSp>
      <p:cxnSp>
        <p:nvCxnSpPr>
          <p:cNvPr id="61" name="直線矢印コネクタ 51"/>
          <p:cNvCxnSpPr>
            <a:stCxn id="49" idx="2"/>
            <a:endCxn id="50" idx="0"/>
          </p:cNvCxnSpPr>
          <p:nvPr/>
        </p:nvCxnSpPr>
        <p:spPr>
          <a:xfrm>
            <a:off x="5276880" y="3398040"/>
            <a:ext cx="360" cy="318600"/>
          </a:xfrm>
          <a:prstGeom prst="straightConnector1">
            <a:avLst/>
          </a:prstGeom>
          <a:ln w="0">
            <a:solidFill>
              <a:srgbClr val="000000"/>
            </a:solidFill>
            <a:tailEnd len="med" type="triangle" w="med"/>
          </a:ln>
        </p:spPr>
      </p:cxnSp>
      <p:cxnSp>
        <p:nvCxnSpPr>
          <p:cNvPr id="62" name="直線矢印コネクタ 54"/>
          <p:cNvCxnSpPr>
            <a:stCxn id="50" idx="2"/>
            <a:endCxn id="52" idx="0"/>
          </p:cNvCxnSpPr>
          <p:nvPr/>
        </p:nvCxnSpPr>
        <p:spPr>
          <a:xfrm>
            <a:off x="5276880" y="4358880"/>
            <a:ext cx="360" cy="391320"/>
          </a:xfrm>
          <a:prstGeom prst="straightConnector1">
            <a:avLst/>
          </a:prstGeom>
          <a:ln w="0">
            <a:solidFill>
              <a:srgbClr val="000000"/>
            </a:solidFill>
            <a:tailEnd len="med" type="triangle" w="med"/>
          </a:ln>
        </p:spPr>
      </p:cxnSp>
      <p:sp>
        <p:nvSpPr>
          <p:cNvPr id="63" name="正方形/長方形 26"/>
          <p:cNvSpPr/>
          <p:nvPr/>
        </p:nvSpPr>
        <p:spPr>
          <a:xfrm>
            <a:off x="1440000" y="7729560"/>
            <a:ext cx="4879800" cy="23112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move the false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gcAB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equences without conserved motifs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4" name="直線矢印コネクタ 27"/>
          <p:cNvCxnSpPr>
            <a:stCxn id="51" idx="2"/>
          </p:cNvCxnSpPr>
          <p:nvPr/>
        </p:nvCxnSpPr>
        <p:spPr>
          <a:xfrm flipH="1">
            <a:off x="2072520" y="7311960"/>
            <a:ext cx="3240" cy="418320"/>
          </a:xfrm>
          <a:prstGeom prst="straightConnector1">
            <a:avLst/>
          </a:prstGeom>
          <a:ln w="0">
            <a:solidFill>
              <a:srgbClr val="000000"/>
            </a:solidFill>
            <a:tailEnd len="med" type="triangle" w="med"/>
          </a:ln>
        </p:spPr>
      </p:cxnSp>
      <p:cxnSp>
        <p:nvCxnSpPr>
          <p:cNvPr id="65" name="直線矢印コネクタ 30"/>
          <p:cNvCxnSpPr>
            <a:stCxn id="53" idx="2"/>
          </p:cNvCxnSpPr>
          <p:nvPr/>
        </p:nvCxnSpPr>
        <p:spPr>
          <a:xfrm>
            <a:off x="3336840" y="6489720"/>
            <a:ext cx="720" cy="1240560"/>
          </a:xfrm>
          <a:prstGeom prst="straightConnector1">
            <a:avLst/>
          </a:prstGeom>
          <a:ln w="0">
            <a:solidFill>
              <a:srgbClr val="000000"/>
            </a:solidFill>
            <a:tailEnd len="med" type="triangle" w="med"/>
          </a:ln>
        </p:spPr>
      </p:cxnSp>
      <p:cxnSp>
        <p:nvCxnSpPr>
          <p:cNvPr id="66" name="直線矢印コネクタ 31"/>
          <p:cNvCxnSpPr>
            <a:stCxn id="52" idx="2"/>
          </p:cNvCxnSpPr>
          <p:nvPr/>
        </p:nvCxnSpPr>
        <p:spPr>
          <a:xfrm>
            <a:off x="5276880" y="5255280"/>
            <a:ext cx="720" cy="2475000"/>
          </a:xfrm>
          <a:prstGeom prst="straightConnector1">
            <a:avLst/>
          </a:prstGeom>
          <a:ln w="0">
            <a:solidFill>
              <a:srgbClr val="000000"/>
            </a:solidFill>
            <a:tailEnd len="med" type="triangle" w="med"/>
          </a:ln>
        </p:spPr>
      </p:cxnSp>
      <p:sp>
        <p:nvSpPr>
          <p:cNvPr id="67" name="テキスト ボックス 33"/>
          <p:cNvSpPr/>
          <p:nvPr/>
        </p:nvSpPr>
        <p:spPr>
          <a:xfrm>
            <a:off x="1211400" y="1643040"/>
            <a:ext cx="17240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Abundance of </a:t>
            </a:r>
            <a:r>
              <a:rPr b="0" i="1" lang="en-US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recA</a:t>
            </a: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 and </a:t>
            </a:r>
            <a:r>
              <a:rPr b="0" i="1" lang="en-US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hgcA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テキスト ボックス 34"/>
          <p:cNvSpPr/>
          <p:nvPr/>
        </p:nvSpPr>
        <p:spPr>
          <a:xfrm>
            <a:off x="4413240" y="1643040"/>
            <a:ext cx="17272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Phylogenetic analysis of </a:t>
            </a:r>
            <a:r>
              <a:rPr b="0" i="1" lang="en-US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hgcA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正方形/長方形 47"/>
          <p:cNvSpPr/>
          <p:nvPr/>
        </p:nvSpPr>
        <p:spPr>
          <a:xfrm>
            <a:off x="343080" y="4749840"/>
            <a:ext cx="1004760" cy="132840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Detection of the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recA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sequences in our metagenomes with the Hidden Markov model (HMM) in HMMER v3.2.1 (Eddy, 2009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0" name="グループ化 1"/>
          <p:cNvGrpSpPr/>
          <p:nvPr/>
        </p:nvGrpSpPr>
        <p:grpSpPr>
          <a:xfrm>
            <a:off x="845280" y="4221720"/>
            <a:ext cx="2491560" cy="528120"/>
            <a:chOff x="845280" y="4221720"/>
            <a:chExt cx="2491560" cy="528120"/>
          </a:xfrm>
        </p:grpSpPr>
        <p:cxnSp>
          <p:nvCxnSpPr>
            <p:cNvPr id="71" name="直線矢印コネクタ 39"/>
            <p:cNvCxnSpPr/>
            <p:nvPr/>
          </p:nvCxnSpPr>
          <p:spPr>
            <a:xfrm>
              <a:off x="2074680" y="4223880"/>
              <a:ext cx="3600" cy="508680"/>
            </a:xfrm>
            <a:prstGeom prst="straightConnector1">
              <a:avLst/>
            </a:prstGeom>
            <a:ln w="0">
              <a:solidFill>
                <a:srgbClr val="000000"/>
              </a:solidFill>
              <a:tailEnd len="med" type="triangle" w="med"/>
            </a:ln>
          </p:spPr>
        </p:cxnSp>
        <p:cxnSp>
          <p:nvCxnSpPr>
            <p:cNvPr id="72" name="直線矢印コネクタ 42"/>
            <p:cNvCxnSpPr>
              <a:stCxn id="46" idx="2"/>
              <a:endCxn id="53" idx="0"/>
            </p:cNvCxnSpPr>
            <p:nvPr/>
          </p:nvCxnSpPr>
          <p:spPr>
            <a:xfrm>
              <a:off x="2073240" y="4221720"/>
              <a:ext cx="1263960" cy="528480"/>
            </a:xfrm>
            <a:prstGeom prst="straightConnector1">
              <a:avLst/>
            </a:prstGeom>
            <a:ln w="0">
              <a:solidFill>
                <a:srgbClr val="000000"/>
              </a:solidFill>
              <a:tailEnd len="med" type="triangle" w="med"/>
            </a:ln>
          </p:spPr>
        </p:cxnSp>
        <p:cxnSp>
          <p:nvCxnSpPr>
            <p:cNvPr id="73" name="直線矢印コネクタ 55"/>
            <p:cNvCxnSpPr>
              <a:stCxn id="46" idx="2"/>
              <a:endCxn id="69" idx="0"/>
            </p:cNvCxnSpPr>
            <p:nvPr/>
          </p:nvCxnSpPr>
          <p:spPr>
            <a:xfrm flipH="1">
              <a:off x="845280" y="4221720"/>
              <a:ext cx="1228320" cy="528480"/>
            </a:xfrm>
            <a:prstGeom prst="straightConnector1">
              <a:avLst/>
            </a:prstGeom>
            <a:ln w="0">
              <a:solidFill>
                <a:srgbClr val="000000"/>
              </a:solidFill>
              <a:tailEnd len="med" type="triangle" w="med"/>
            </a:ln>
          </p:spPr>
        </p:cxnSp>
      </p:grpSp>
      <p:sp>
        <p:nvSpPr>
          <p:cNvPr id="74" name="正方形/長方形 60"/>
          <p:cNvSpPr/>
          <p:nvPr/>
        </p:nvSpPr>
        <p:spPr>
          <a:xfrm>
            <a:off x="344520" y="6257880"/>
            <a:ext cx="1003320" cy="105408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Re-check the specificity of HMMs for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recA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sequences using hmmsearch (HMMER v3.2.1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5" name="直線矢印コネクタ 61"/>
          <p:cNvCxnSpPr>
            <a:stCxn id="69" idx="2"/>
          </p:cNvCxnSpPr>
          <p:nvPr/>
        </p:nvCxnSpPr>
        <p:spPr>
          <a:xfrm>
            <a:off x="845280" y="6078240"/>
            <a:ext cx="1440" cy="180360"/>
          </a:xfrm>
          <a:prstGeom prst="straightConnector1">
            <a:avLst/>
          </a:prstGeom>
          <a:ln w="0">
            <a:solidFill>
              <a:srgbClr val="000000"/>
            </a:solidFill>
            <a:tailEnd len="med" type="triangle" w="med"/>
          </a:ln>
        </p:spPr>
      </p:cxnSp>
      <p:sp>
        <p:nvSpPr>
          <p:cNvPr id="76" name="テキスト ボックス 37"/>
          <p:cNvSpPr/>
          <p:nvPr/>
        </p:nvSpPr>
        <p:spPr>
          <a:xfrm>
            <a:off x="1517760" y="1355760"/>
            <a:ext cx="1172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 u="sng">
                <a:solidFill>
                  <a:srgbClr val="000000"/>
                </a:solidFill>
                <a:uFillTx/>
                <a:latin typeface="Arial"/>
                <a:ea typeface="Arial"/>
              </a:rPr>
              <a:t>Paired-en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テキスト ボックス 49"/>
          <p:cNvSpPr/>
          <p:nvPr/>
        </p:nvSpPr>
        <p:spPr>
          <a:xfrm>
            <a:off x="4429440" y="1343160"/>
            <a:ext cx="1683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 u="sng">
                <a:solidFill>
                  <a:srgbClr val="000000"/>
                </a:solidFill>
                <a:uFillTx/>
                <a:latin typeface="Arial"/>
                <a:ea typeface="Arial"/>
              </a:rPr>
              <a:t>Contig assembly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1" name="グループ化 3"/>
          <p:cNvGrpSpPr/>
          <p:nvPr/>
        </p:nvGrpSpPr>
        <p:grpSpPr>
          <a:xfrm>
            <a:off x="963720" y="2664000"/>
            <a:ext cx="4690800" cy="3100680"/>
            <a:chOff x="963720" y="2664000"/>
            <a:chExt cx="4690800" cy="3100680"/>
          </a:xfrm>
        </p:grpSpPr>
        <p:pic>
          <p:nvPicPr>
            <p:cNvPr id="332" name="グラフ 4" descr=""/>
            <p:cNvPicPr/>
            <p:nvPr/>
          </p:nvPicPr>
          <p:blipFill>
            <a:blip r:embed="rId1"/>
            <a:stretch/>
          </p:blipFill>
          <p:spPr>
            <a:xfrm>
              <a:off x="1194480" y="2664000"/>
              <a:ext cx="4460040" cy="2926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33" name="テキスト ボックス 5"/>
            <p:cNvSpPr/>
            <p:nvPr/>
          </p:nvSpPr>
          <p:spPr>
            <a:xfrm rot="16200000">
              <a:off x="-201600" y="3926520"/>
              <a:ext cx="25621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o. of operational taxonomic units (OTUs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4" name="テキスト ボックス 6"/>
            <p:cNvSpPr/>
            <p:nvPr/>
          </p:nvSpPr>
          <p:spPr>
            <a:xfrm>
              <a:off x="1927080" y="5533560"/>
              <a:ext cx="19893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o. of 16S rRNA sequence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35" name="テキスト ボックス 8"/>
          <p:cNvSpPr/>
          <p:nvPr/>
        </p:nvSpPr>
        <p:spPr>
          <a:xfrm>
            <a:off x="563400" y="6008760"/>
            <a:ext cx="57232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0. Rarefaction curve of operational taxonomic units (OTUs) for 16S rRNA sequences in each sample. The OTUs were classified by &gt;97% similarity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6" name="グループ化 1"/>
          <p:cNvGrpSpPr/>
          <p:nvPr/>
        </p:nvGrpSpPr>
        <p:grpSpPr>
          <a:xfrm>
            <a:off x="1127160" y="1749600"/>
            <a:ext cx="4519440" cy="5123160"/>
            <a:chOff x="1127160" y="1749600"/>
            <a:chExt cx="4519440" cy="5123160"/>
          </a:xfrm>
        </p:grpSpPr>
        <p:pic>
          <p:nvPicPr>
            <p:cNvPr id="337" name="グラフ 14" descr=""/>
            <p:cNvPicPr/>
            <p:nvPr/>
          </p:nvPicPr>
          <p:blipFill>
            <a:blip r:embed="rId1"/>
            <a:stretch/>
          </p:blipFill>
          <p:spPr>
            <a:xfrm>
              <a:off x="1493640" y="4194000"/>
              <a:ext cx="4152960" cy="2432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38" name="グラフ 13" descr=""/>
            <p:cNvPicPr/>
            <p:nvPr/>
          </p:nvPicPr>
          <p:blipFill>
            <a:blip r:embed="rId2"/>
            <a:stretch/>
          </p:blipFill>
          <p:spPr>
            <a:xfrm>
              <a:off x="1493640" y="1749600"/>
              <a:ext cx="4152960" cy="2432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39" name="テキスト ボックス 7"/>
            <p:cNvSpPr/>
            <p:nvPr/>
          </p:nvSpPr>
          <p:spPr>
            <a:xfrm>
              <a:off x="2700000" y="6641640"/>
              <a:ext cx="12582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o. of query sequence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0" name="テキスト ボックス 8"/>
            <p:cNvSpPr/>
            <p:nvPr/>
          </p:nvSpPr>
          <p:spPr>
            <a:xfrm rot="16200000">
              <a:off x="301680" y="2751480"/>
              <a:ext cx="2021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o. of KEGG orthologues (in genes) assigned to query sequences 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1" name="テキスト ボックス 9"/>
            <p:cNvSpPr/>
            <p:nvPr/>
          </p:nvSpPr>
          <p:spPr>
            <a:xfrm rot="16200000">
              <a:off x="300600" y="5163480"/>
              <a:ext cx="2021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o. of KEGG orthologues (in modules) assigned to query sequences 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2" name="テキスト ボックス 10"/>
            <p:cNvSpPr/>
            <p:nvPr/>
          </p:nvSpPr>
          <p:spPr>
            <a:xfrm>
              <a:off x="1868040" y="1903320"/>
              <a:ext cx="390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A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3" name="テキスト ボックス 11"/>
            <p:cNvSpPr/>
            <p:nvPr/>
          </p:nvSpPr>
          <p:spPr>
            <a:xfrm>
              <a:off x="1868040" y="4337280"/>
              <a:ext cx="383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B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44" name="テキスト ボックス 12"/>
          <p:cNvSpPr/>
          <p:nvPr/>
        </p:nvSpPr>
        <p:spPr>
          <a:xfrm>
            <a:off x="568440" y="7120080"/>
            <a:ext cx="57211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1. Rarefaction curvse for the number of KEGG orthologues in genes (A) and modules (B), assigned to query sequence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5" name="テキスト ボックス 7"/>
          <p:cNvSpPr/>
          <p:nvPr/>
        </p:nvSpPr>
        <p:spPr>
          <a:xfrm>
            <a:off x="457200" y="6370560"/>
            <a:ext cx="59436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2. Rarefaction curves of sequence abundance and operational taxonomic units (OTUs)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gc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A and B) and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gc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C and D) genes, respectively. Analyzed using the paired-end metagenomic sequences obtained from 500 m and 800 m depths at Sts 0 and 1. The OTUs were classified by &gt;90% similarity, using the CD-HIT program (Fu et al., 2012)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6" name="テキスト ボックス 8"/>
          <p:cNvSpPr/>
          <p:nvPr/>
        </p:nvSpPr>
        <p:spPr>
          <a:xfrm>
            <a:off x="1365120" y="2406600"/>
            <a:ext cx="39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7" name="テキスト ボックス 9"/>
          <p:cNvSpPr/>
          <p:nvPr/>
        </p:nvSpPr>
        <p:spPr>
          <a:xfrm>
            <a:off x="3563280" y="2406600"/>
            <a:ext cx="383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8" name="テキスト ボックス 14"/>
          <p:cNvSpPr/>
          <p:nvPr/>
        </p:nvSpPr>
        <p:spPr>
          <a:xfrm>
            <a:off x="1364760" y="4106880"/>
            <a:ext cx="383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C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9" name="テキスト ボックス 15"/>
          <p:cNvSpPr/>
          <p:nvPr/>
        </p:nvSpPr>
        <p:spPr>
          <a:xfrm>
            <a:off x="3563640" y="4106880"/>
            <a:ext cx="39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D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50" name="グラフ 16" descr=""/>
          <p:cNvPicPr/>
          <p:nvPr/>
        </p:nvPicPr>
        <p:blipFill>
          <a:blip r:embed="rId1"/>
          <a:stretch/>
        </p:blipFill>
        <p:spPr>
          <a:xfrm>
            <a:off x="927000" y="2328840"/>
            <a:ext cx="2541600" cy="1882800"/>
          </a:xfrm>
          <a:prstGeom prst="rect">
            <a:avLst/>
          </a:prstGeom>
          <a:ln w="0">
            <a:noFill/>
          </a:ln>
        </p:spPr>
      </p:pic>
      <p:pic>
        <p:nvPicPr>
          <p:cNvPr id="351" name="グラフ 17" descr=""/>
          <p:cNvPicPr/>
          <p:nvPr/>
        </p:nvPicPr>
        <p:blipFill>
          <a:blip r:embed="rId2"/>
          <a:stretch/>
        </p:blipFill>
        <p:spPr>
          <a:xfrm>
            <a:off x="3187800" y="2335320"/>
            <a:ext cx="2889000" cy="1882800"/>
          </a:xfrm>
          <a:prstGeom prst="rect">
            <a:avLst/>
          </a:prstGeom>
          <a:ln w="0">
            <a:noFill/>
          </a:ln>
        </p:spPr>
      </p:pic>
      <p:pic>
        <p:nvPicPr>
          <p:cNvPr id="352" name="グラフ 18" descr=""/>
          <p:cNvPicPr/>
          <p:nvPr/>
        </p:nvPicPr>
        <p:blipFill>
          <a:blip r:embed="rId3"/>
          <a:stretch/>
        </p:blipFill>
        <p:spPr>
          <a:xfrm>
            <a:off x="927000" y="4035600"/>
            <a:ext cx="2541600" cy="1884240"/>
          </a:xfrm>
          <a:prstGeom prst="rect">
            <a:avLst/>
          </a:prstGeom>
          <a:ln w="0">
            <a:noFill/>
          </a:ln>
        </p:spPr>
      </p:pic>
      <p:pic>
        <p:nvPicPr>
          <p:cNvPr id="353" name="グラフ 19" descr=""/>
          <p:cNvPicPr/>
          <p:nvPr/>
        </p:nvPicPr>
        <p:blipFill>
          <a:blip r:embed="rId4"/>
          <a:stretch/>
        </p:blipFill>
        <p:spPr>
          <a:xfrm>
            <a:off x="3187800" y="4035600"/>
            <a:ext cx="2889000" cy="1884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4" name="テキスト ボックス 3"/>
          <p:cNvSpPr/>
          <p:nvPr/>
        </p:nvSpPr>
        <p:spPr>
          <a:xfrm>
            <a:off x="652320" y="555480"/>
            <a:ext cx="5553360" cy="775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ferenc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ristensen, G. A., Gionfriddo, C. M., King, A. J., Moberly, J. G., Miller, C. L., Somenahally, A. C., et al. (2019). Determining the reliability of measuring mercury cycling gene abundance with correlations with mercury and methylmercury concentrations.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nviron. Sci. Technol.,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53, 8649-8663. doi:10.1021/acs.est.8b0638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ddy, S. R. (2009). A new generation of homology search tools based on probabilistic inference. In Genome Informatics 2009: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nome. Inform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,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3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205-211. doi: 10.1142/9781848165632_001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u, L., Niu, B., Zhu, Z., Wu, S., Li, W. (2012). CD-HIT: accelerated for clustering the next-generation sequencing data.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ioinfomatic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28, 3150-3152. doi: 10.1093/bioinformatics/bts56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ilmour, C. C., Podar, M., Bullock, A. L., Graham, A. M., Brown, S. D., Somenahally, A. C.,et al. (2013). Mercury methylation by novel microorganisms from new environments.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nviron. Sci. Technol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47, 11810-11820. doi: 10.1021/es403075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ilmour, C. C., Bullock, A. L., McBurney, A., Podar, M., and Elias, D. A. (2018). Robust mercury methylation across diverse methanogenic Archaea.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Bio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9, e02403- e02417. doi: 10.1128/mBio.02403-1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ionfriddo, C. M., Tate, M. T., Wick, R. R., Schultz, M. B., Zemla, A., Thelen, M. P., et al. (2016). Microbial mercury methylation in Antarctic sea ice.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at. Microbiol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1, 16127. doi: 10.1038/nmicrobiol.2016.12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Jones, D. S., Walker, G. M., Johnson, N. W., Mitchell, C. P., Wasik, J. K. C., and Bailey, J. V. (2019). Molecular evidence for novel mercury methylating microorganisms in sulfate-impacted lakes. ISME J. 13, 1659-1675. doi: 10.1038/s41396-019-0376-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i, D., Luo, R., Liu, C. M., Leung, C. M., Ting, H. F., Sadakane, K., et al. (2016). MEGAHIT v1. 0: a fast and scalable metagenome assembler driven by advanced methodologies and community practices.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ethod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102, 3-11. doi: 10.1016/j.ymeth.2016.02.02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artin, M. (2011). Cutadapt removes adapter sequences from high-throughput sequencing reads. EMBnet. journal, 17, 10-12. doi: 10.14806/ej.17.1.2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chmieder, R., and Edwards, R. (2011). Quality control and preprocessing of metagenomic datasets.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ioinform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2, 863-864. doi: 10.1093/bioinformatics/btr02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oguchi, H., Taniguchi, T., and Itoh, T. (2008). MetaGeneAnnotator: detecting species-specific patterns of ribosomal binding site for precise gene prediction in anonymous prokaryotic and phage genomes.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NA Res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15, 387-396. doi: 10.1093/dnares/dsn02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kami, H., Taniguchi, T., Arai, W., Takemoto, K., Moriya, Y., and Goto, S. (2016). An automated system for evaluation of the potential functionome: MAPLE version 2.1. 0.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NA Res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23, 467-475. doi: 10.1093/dnares/dsw03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Zhang, J., Kobert, K., Flouri, T., and Stamatakis, A. (2013). PEAR: a fast and accurate Illumina Paired-End reAd mergeR.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ioinform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, 30, 614-620. doi: 10.1093/bioinformatics/btt59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テキスト ボックス 7"/>
          <p:cNvSpPr/>
          <p:nvPr/>
        </p:nvSpPr>
        <p:spPr>
          <a:xfrm>
            <a:off x="457200" y="5154480"/>
            <a:ext cx="59436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2. Relationship between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gc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ene abundance and THg (A), and MeHg (B), and MeHg/THg (C) at each station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9" name="グループ化 1"/>
          <p:cNvGrpSpPr/>
          <p:nvPr/>
        </p:nvGrpSpPr>
        <p:grpSpPr>
          <a:xfrm>
            <a:off x="611280" y="2940120"/>
            <a:ext cx="5589360" cy="1942200"/>
            <a:chOff x="611280" y="2940120"/>
            <a:chExt cx="5589360" cy="1942200"/>
          </a:xfrm>
        </p:grpSpPr>
        <p:pic>
          <p:nvPicPr>
            <p:cNvPr id="80" name="グラフ 3" descr=""/>
            <p:cNvPicPr/>
            <p:nvPr/>
          </p:nvPicPr>
          <p:blipFill>
            <a:blip r:embed="rId1"/>
            <a:stretch/>
          </p:blipFill>
          <p:spPr>
            <a:xfrm>
              <a:off x="859680" y="2940120"/>
              <a:ext cx="1816920" cy="1760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1" name="グラフ 4" descr=""/>
            <p:cNvPicPr/>
            <p:nvPr/>
          </p:nvPicPr>
          <p:blipFill>
            <a:blip r:embed="rId2"/>
            <a:stretch/>
          </p:blipFill>
          <p:spPr>
            <a:xfrm>
              <a:off x="2621520" y="2940120"/>
              <a:ext cx="1816920" cy="1760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2" name="グラフ 5" descr=""/>
            <p:cNvPicPr/>
            <p:nvPr/>
          </p:nvPicPr>
          <p:blipFill>
            <a:blip r:embed="rId3"/>
            <a:stretch/>
          </p:blipFill>
          <p:spPr>
            <a:xfrm>
              <a:off x="4383720" y="2940120"/>
              <a:ext cx="1816920" cy="1760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3" name="テキスト ボックス 6"/>
            <p:cNvSpPr/>
            <p:nvPr/>
          </p:nvSpPr>
          <p:spPr>
            <a:xfrm rot="16200000">
              <a:off x="110880" y="3629520"/>
              <a:ext cx="12319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o. of </a:t>
              </a:r>
              <a:r>
                <a:rPr b="0" i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gcA</a:t>
              </a: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sequence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テキスト ボックス 8"/>
            <p:cNvSpPr/>
            <p:nvPr/>
          </p:nvSpPr>
          <p:spPr>
            <a:xfrm>
              <a:off x="1083600" y="2983320"/>
              <a:ext cx="390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A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テキスト ボックス 9"/>
            <p:cNvSpPr/>
            <p:nvPr/>
          </p:nvSpPr>
          <p:spPr>
            <a:xfrm>
              <a:off x="2845800" y="2983320"/>
              <a:ext cx="383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B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テキスト ボックス 10"/>
            <p:cNvSpPr/>
            <p:nvPr/>
          </p:nvSpPr>
          <p:spPr>
            <a:xfrm>
              <a:off x="4607640" y="2983320"/>
              <a:ext cx="383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C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テキスト ボックス 11"/>
            <p:cNvSpPr/>
            <p:nvPr/>
          </p:nvSpPr>
          <p:spPr>
            <a:xfrm>
              <a:off x="1208880" y="4651200"/>
              <a:ext cx="1252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Hg (pM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テキスト ボックス 13"/>
            <p:cNvSpPr/>
            <p:nvPr/>
          </p:nvSpPr>
          <p:spPr>
            <a:xfrm>
              <a:off x="4741920" y="4651200"/>
              <a:ext cx="1252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eHg / THg (%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テキスト ボックス 14"/>
            <p:cNvSpPr/>
            <p:nvPr/>
          </p:nvSpPr>
          <p:spPr>
            <a:xfrm>
              <a:off x="2975400" y="4651200"/>
              <a:ext cx="1252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eHg (pM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テキスト ボックス 3"/>
          <p:cNvSpPr/>
          <p:nvPr/>
        </p:nvSpPr>
        <p:spPr>
          <a:xfrm>
            <a:off x="673200" y="6140520"/>
            <a:ext cx="54021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3. The relative abundance of phylogenetic lineages to total 16S rRNA sequence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91" name="グループ化 2"/>
          <p:cNvGrpSpPr/>
          <p:nvPr/>
        </p:nvGrpSpPr>
        <p:grpSpPr>
          <a:xfrm>
            <a:off x="1238400" y="2703600"/>
            <a:ext cx="4572000" cy="3317760"/>
            <a:chOff x="1238400" y="2703600"/>
            <a:chExt cx="4572000" cy="3317760"/>
          </a:xfrm>
        </p:grpSpPr>
        <p:pic>
          <p:nvPicPr>
            <p:cNvPr id="92" name="グラフ 6" descr=""/>
            <p:cNvPicPr/>
            <p:nvPr/>
          </p:nvPicPr>
          <p:blipFill>
            <a:blip r:embed="rId1"/>
            <a:stretch/>
          </p:blipFill>
          <p:spPr>
            <a:xfrm>
              <a:off x="1377720" y="2703600"/>
              <a:ext cx="4432680" cy="3317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3" name="テキスト ボックス 5"/>
            <p:cNvSpPr/>
            <p:nvPr/>
          </p:nvSpPr>
          <p:spPr>
            <a:xfrm rot="16200000">
              <a:off x="105120" y="4030920"/>
              <a:ext cx="24973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roportion of total 16S rRNA amplicon sequence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テキスト ボックス 5"/>
          <p:cNvSpPr/>
          <p:nvPr/>
        </p:nvSpPr>
        <p:spPr>
          <a:xfrm rot="16200000">
            <a:off x="-704160" y="3555000"/>
            <a:ext cx="24973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roportion of total 16S rRNA amplicon sequences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テキスト ボックス 6"/>
          <p:cNvSpPr/>
          <p:nvPr/>
        </p:nvSpPr>
        <p:spPr>
          <a:xfrm rot="16200000">
            <a:off x="1857240" y="3554280"/>
            <a:ext cx="2405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roportion of total deltaroteobacterial sequences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テキスト ボックス 7"/>
          <p:cNvSpPr/>
          <p:nvPr/>
        </p:nvSpPr>
        <p:spPr>
          <a:xfrm>
            <a:off x="771480" y="5427720"/>
            <a:ext cx="53625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4. The relative abundance of deltaproteobacterial lineages to the total 16S rRNA gene (A) and deltaproteobacterial (B) sequence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テキスト ボックス 8"/>
          <p:cNvSpPr/>
          <p:nvPr/>
        </p:nvSpPr>
        <p:spPr>
          <a:xfrm>
            <a:off x="465480" y="2227320"/>
            <a:ext cx="39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テキスト ボックス 9"/>
          <p:cNvSpPr/>
          <p:nvPr/>
        </p:nvSpPr>
        <p:spPr>
          <a:xfrm>
            <a:off x="2981520" y="2227320"/>
            <a:ext cx="383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9" name="グラフ 10" descr=""/>
          <p:cNvPicPr/>
          <p:nvPr/>
        </p:nvPicPr>
        <p:blipFill>
          <a:blip r:embed="rId1"/>
          <a:stretch/>
        </p:blipFill>
        <p:spPr>
          <a:xfrm>
            <a:off x="639720" y="2530440"/>
            <a:ext cx="2219400" cy="2584440"/>
          </a:xfrm>
          <a:prstGeom prst="rect">
            <a:avLst/>
          </a:prstGeom>
          <a:ln w="0">
            <a:noFill/>
          </a:ln>
        </p:spPr>
      </p:pic>
      <p:pic>
        <p:nvPicPr>
          <p:cNvPr id="100" name="グラフ 11" descr=""/>
          <p:cNvPicPr/>
          <p:nvPr/>
        </p:nvPicPr>
        <p:blipFill>
          <a:blip r:embed="rId2"/>
          <a:stretch/>
        </p:blipFill>
        <p:spPr>
          <a:xfrm>
            <a:off x="3133800" y="2530440"/>
            <a:ext cx="3475080" cy="2644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テキスト ボックス 14"/>
          <p:cNvSpPr/>
          <p:nvPr/>
        </p:nvSpPr>
        <p:spPr>
          <a:xfrm>
            <a:off x="549360" y="7005600"/>
            <a:ext cx="57211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5. Vertical distribution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sulfobulbaceae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,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sulfuromonadaceae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,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dellovibrionaceae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C), and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yntrophobacteraceae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D) affiliated with Deltaproteobacteria,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rmoplasmata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E) affiliated with Euryarchaeota, and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lostridi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F) affiliated with Firmicute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2" name="グラフ 41" descr=""/>
          <p:cNvPicPr/>
          <p:nvPr/>
        </p:nvPicPr>
        <p:blipFill>
          <a:blip r:embed="rId1"/>
          <a:stretch/>
        </p:blipFill>
        <p:spPr>
          <a:xfrm>
            <a:off x="3986280" y="4475160"/>
            <a:ext cx="1708200" cy="2382840"/>
          </a:xfrm>
          <a:prstGeom prst="rect">
            <a:avLst/>
          </a:prstGeom>
          <a:ln w="0">
            <a:noFill/>
          </a:ln>
        </p:spPr>
      </p:pic>
      <p:pic>
        <p:nvPicPr>
          <p:cNvPr id="103" name="グラフ 29" descr=""/>
          <p:cNvPicPr/>
          <p:nvPr/>
        </p:nvPicPr>
        <p:blipFill>
          <a:blip r:embed="rId2"/>
          <a:stretch/>
        </p:blipFill>
        <p:spPr>
          <a:xfrm>
            <a:off x="3968640" y="1914480"/>
            <a:ext cx="1725840" cy="2286000"/>
          </a:xfrm>
          <a:prstGeom prst="rect">
            <a:avLst/>
          </a:prstGeom>
          <a:ln w="0">
            <a:noFill/>
          </a:ln>
        </p:spPr>
      </p:pic>
      <p:sp>
        <p:nvSpPr>
          <p:cNvPr id="104" name="テキスト ボックス 30"/>
          <p:cNvSpPr/>
          <p:nvPr/>
        </p:nvSpPr>
        <p:spPr>
          <a:xfrm>
            <a:off x="4138560" y="1517760"/>
            <a:ext cx="150804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dellovibrionacea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% of total 16S rRNA amplicon seqs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テキスト ボックス 31"/>
          <p:cNvSpPr/>
          <p:nvPr/>
        </p:nvSpPr>
        <p:spPr>
          <a:xfrm>
            <a:off x="4046040" y="1616040"/>
            <a:ext cx="383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C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6" name="グラフ 23" descr=""/>
          <p:cNvPicPr/>
          <p:nvPr/>
        </p:nvPicPr>
        <p:blipFill>
          <a:blip r:embed="rId3"/>
          <a:stretch/>
        </p:blipFill>
        <p:spPr>
          <a:xfrm>
            <a:off x="2571840" y="1920960"/>
            <a:ext cx="1714320" cy="2279520"/>
          </a:xfrm>
          <a:prstGeom prst="rect">
            <a:avLst/>
          </a:prstGeom>
          <a:ln w="0">
            <a:noFill/>
          </a:ln>
        </p:spPr>
      </p:pic>
      <p:sp>
        <p:nvSpPr>
          <p:cNvPr id="107" name="テキスト ボックス 32"/>
          <p:cNvSpPr/>
          <p:nvPr/>
        </p:nvSpPr>
        <p:spPr>
          <a:xfrm>
            <a:off x="2751120" y="1525680"/>
            <a:ext cx="150804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sulfuromonadacea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% of total 16S rRNA amplicon seqs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テキスト ボックス 33"/>
          <p:cNvSpPr/>
          <p:nvPr/>
        </p:nvSpPr>
        <p:spPr>
          <a:xfrm>
            <a:off x="2671200" y="1623960"/>
            <a:ext cx="383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9" name="グラフ 36" descr=""/>
          <p:cNvPicPr/>
          <p:nvPr/>
        </p:nvPicPr>
        <p:blipFill>
          <a:blip r:embed="rId4"/>
          <a:stretch/>
        </p:blipFill>
        <p:spPr>
          <a:xfrm>
            <a:off x="2560680" y="4479840"/>
            <a:ext cx="1706400" cy="2317680"/>
          </a:xfrm>
          <a:prstGeom prst="rect">
            <a:avLst/>
          </a:prstGeom>
          <a:ln w="0">
            <a:noFill/>
          </a:ln>
        </p:spPr>
      </p:pic>
      <p:sp>
        <p:nvSpPr>
          <p:cNvPr id="110" name="テキスト ボックス 37"/>
          <p:cNvSpPr/>
          <p:nvPr/>
        </p:nvSpPr>
        <p:spPr>
          <a:xfrm>
            <a:off x="2759040" y="4110120"/>
            <a:ext cx="150804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rmoplasmat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% of total 16S rRNA amplicon seqs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テキスト ボックス 39"/>
          <p:cNvSpPr/>
          <p:nvPr/>
        </p:nvSpPr>
        <p:spPr>
          <a:xfrm>
            <a:off x="2650320" y="4200480"/>
            <a:ext cx="37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E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テキスト ボックス 40"/>
          <p:cNvSpPr/>
          <p:nvPr/>
        </p:nvSpPr>
        <p:spPr>
          <a:xfrm rot="16200000">
            <a:off x="768960" y="5577480"/>
            <a:ext cx="654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pth (m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テキスト ボックス 42"/>
          <p:cNvSpPr/>
          <p:nvPr/>
        </p:nvSpPr>
        <p:spPr>
          <a:xfrm>
            <a:off x="4164120" y="4110120"/>
            <a:ext cx="150948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lostridi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% of total 16S rRNA amplicon seqs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テキスト ボックス 43"/>
          <p:cNvSpPr/>
          <p:nvPr/>
        </p:nvSpPr>
        <p:spPr>
          <a:xfrm>
            <a:off x="4070160" y="4206960"/>
            <a:ext cx="36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F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テキスト ボックス 24"/>
          <p:cNvSpPr/>
          <p:nvPr/>
        </p:nvSpPr>
        <p:spPr>
          <a:xfrm>
            <a:off x="1465200" y="1530360"/>
            <a:ext cx="127476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sulfobulbacea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% of total 16S rRNA amplicon seqs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テキスト ボックス 27"/>
          <p:cNvSpPr/>
          <p:nvPr/>
        </p:nvSpPr>
        <p:spPr>
          <a:xfrm>
            <a:off x="1256040" y="1628640"/>
            <a:ext cx="39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テキスト ボックス 20"/>
          <p:cNvSpPr/>
          <p:nvPr/>
        </p:nvSpPr>
        <p:spPr>
          <a:xfrm rot="16200000">
            <a:off x="768960" y="2996280"/>
            <a:ext cx="654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pth (m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8" name="グラフ 10" descr=""/>
          <p:cNvPicPr/>
          <p:nvPr/>
        </p:nvPicPr>
        <p:blipFill>
          <a:blip r:embed="rId5"/>
          <a:stretch/>
        </p:blipFill>
        <p:spPr>
          <a:xfrm>
            <a:off x="1170000" y="1914480"/>
            <a:ext cx="1712880" cy="2371680"/>
          </a:xfrm>
          <a:prstGeom prst="rect">
            <a:avLst/>
          </a:prstGeom>
          <a:ln w="0">
            <a:noFill/>
          </a:ln>
        </p:spPr>
      </p:pic>
      <p:pic>
        <p:nvPicPr>
          <p:cNvPr id="119" name="図 8" descr=""/>
          <p:cNvPicPr/>
          <p:nvPr/>
        </p:nvPicPr>
        <p:blipFill>
          <a:blip r:embed="rId6"/>
          <a:stretch/>
        </p:blipFill>
        <p:spPr>
          <a:xfrm>
            <a:off x="2160720" y="3571920"/>
            <a:ext cx="466560" cy="425520"/>
          </a:xfrm>
          <a:prstGeom prst="rect">
            <a:avLst/>
          </a:prstGeom>
          <a:ln w="0">
            <a:noFill/>
          </a:ln>
        </p:spPr>
      </p:pic>
      <p:sp>
        <p:nvSpPr>
          <p:cNvPr id="120" name="テキスト ボックス 26"/>
          <p:cNvSpPr/>
          <p:nvPr/>
        </p:nvSpPr>
        <p:spPr>
          <a:xfrm>
            <a:off x="1357200" y="4095720"/>
            <a:ext cx="150984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yntrophobacteracea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% of total 16S rRNA amplicon seqs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テキスト ボックス 28"/>
          <p:cNvSpPr/>
          <p:nvPr/>
        </p:nvSpPr>
        <p:spPr>
          <a:xfrm>
            <a:off x="1244160" y="4194000"/>
            <a:ext cx="39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D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2" name="グラフ 25" descr=""/>
          <p:cNvPicPr/>
          <p:nvPr/>
        </p:nvPicPr>
        <p:blipFill>
          <a:blip r:embed="rId7"/>
          <a:stretch/>
        </p:blipFill>
        <p:spPr>
          <a:xfrm>
            <a:off x="1158840" y="4498920"/>
            <a:ext cx="1724040" cy="2279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テキスト ボックス 112"/>
          <p:cNvSpPr/>
          <p:nvPr/>
        </p:nvSpPr>
        <p:spPr>
          <a:xfrm>
            <a:off x="270000" y="7839000"/>
            <a:ext cx="634176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6. Maximum likelihood tree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gc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like sequences identified in the assembled-metagenomic contigs from mesopelagic layers (500 m and 800 m depths) at Sts. 0 and 1. Sequences identified in this study (shown in red) are compared with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gc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homologues described in previous reports (Gilmour et al., 2013; Gionfriddo et al., 2016; Gilmour et al., 2018; Christensen et al., 2019; Jones et al., 2019). Bootstrap values &gt;50 are shown, with consensus based on 100 replicates. NCBI accession number are provided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4" name="図 15" descr=""/>
          <p:cNvPicPr/>
          <p:nvPr/>
        </p:nvPicPr>
        <p:blipFill>
          <a:blip r:embed="rId1"/>
          <a:stretch/>
        </p:blipFill>
        <p:spPr>
          <a:xfrm>
            <a:off x="1539720" y="436680"/>
            <a:ext cx="1435320" cy="7143480"/>
          </a:xfrm>
          <a:prstGeom prst="rect">
            <a:avLst/>
          </a:prstGeom>
          <a:ln w="0">
            <a:noFill/>
          </a:ln>
        </p:spPr>
      </p:pic>
      <p:sp>
        <p:nvSpPr>
          <p:cNvPr id="125" name="テキスト ボックス 5"/>
          <p:cNvSpPr/>
          <p:nvPr/>
        </p:nvSpPr>
        <p:spPr>
          <a:xfrm>
            <a:off x="2860560" y="365040"/>
            <a:ext cx="739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Deltaproteobacteri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正方形/長方形 6"/>
          <p:cNvSpPr/>
          <p:nvPr/>
        </p:nvSpPr>
        <p:spPr>
          <a:xfrm>
            <a:off x="2198520" y="436680"/>
            <a:ext cx="16862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acteroidetes cellulosolvens 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SM2933 WP03693562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正方形/長方形 8"/>
          <p:cNvSpPr/>
          <p:nvPr/>
        </p:nvSpPr>
        <p:spPr>
          <a:xfrm>
            <a:off x="2864520" y="495360"/>
            <a:ext cx="5252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halobacter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正方形/長方形 9"/>
          <p:cNvSpPr/>
          <p:nvPr/>
        </p:nvSpPr>
        <p:spPr>
          <a:xfrm>
            <a:off x="2208240" y="569880"/>
            <a:ext cx="162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cetivibrio cellulolyticus 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SM1870 (2510774675)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正方形/長方形 10"/>
          <p:cNvSpPr/>
          <p:nvPr/>
        </p:nvSpPr>
        <p:spPr>
          <a:xfrm>
            <a:off x="2879640" y="631800"/>
            <a:ext cx="668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uminiclostridium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正方形/長方形 11"/>
          <p:cNvSpPr/>
          <p:nvPr/>
        </p:nvSpPr>
        <p:spPr>
          <a:xfrm>
            <a:off x="2208240" y="696960"/>
            <a:ext cx="162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yntrophobotulus glycolicus 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SM8271 (ADY56638)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正方形/長方形 12"/>
          <p:cNvSpPr/>
          <p:nvPr/>
        </p:nvSpPr>
        <p:spPr>
          <a:xfrm>
            <a:off x="2176560" y="768240"/>
            <a:ext cx="15285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thanoligenens harbinense 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UAN3 (ADU26529)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正方形/長方形 13"/>
          <p:cNvSpPr/>
          <p:nvPr/>
        </p:nvSpPr>
        <p:spPr>
          <a:xfrm>
            <a:off x="2871720" y="826920"/>
            <a:ext cx="5922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aerocolumn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正方形/長方形 14"/>
          <p:cNvSpPr/>
          <p:nvPr/>
        </p:nvSpPr>
        <p:spPr>
          <a:xfrm>
            <a:off x="2871720" y="901800"/>
            <a:ext cx="4701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itrospirae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正方形/長方形 16"/>
          <p:cNvSpPr/>
          <p:nvPr/>
        </p:nvSpPr>
        <p:spPr>
          <a:xfrm>
            <a:off x="2872440" y="968400"/>
            <a:ext cx="5097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pirochaetes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正方形/長方形 17"/>
          <p:cNvSpPr/>
          <p:nvPr/>
        </p:nvSpPr>
        <p:spPr>
          <a:xfrm>
            <a:off x="2872440" y="1039680"/>
            <a:ext cx="5097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pirochaetes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正方形/長方形 18"/>
          <p:cNvSpPr/>
          <p:nvPr/>
        </p:nvSpPr>
        <p:spPr>
          <a:xfrm>
            <a:off x="2340000" y="1108080"/>
            <a:ext cx="16606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yntrophorhabdus aromaticivorans 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2509867055)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正方形/長方形 19"/>
          <p:cNvSpPr/>
          <p:nvPr/>
        </p:nvSpPr>
        <p:spPr>
          <a:xfrm>
            <a:off x="2232000" y="1174680"/>
            <a:ext cx="18525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lusimicrobia bacterium RIFOXYA2 FULL 47 53 OGS16463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正方形/長方形 20"/>
          <p:cNvSpPr/>
          <p:nvPr/>
        </p:nvSpPr>
        <p:spPr>
          <a:xfrm>
            <a:off x="2872440" y="1236600"/>
            <a:ext cx="5097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pirochaetes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正方形/長方形 21"/>
          <p:cNvSpPr/>
          <p:nvPr/>
        </p:nvSpPr>
        <p:spPr>
          <a:xfrm>
            <a:off x="2206800" y="1306440"/>
            <a:ext cx="1601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pirochaetes bacterium GWE2 31 10 OHD50057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正方形/長方形 22"/>
          <p:cNvSpPr/>
          <p:nvPr/>
        </p:nvSpPr>
        <p:spPr>
          <a:xfrm>
            <a:off x="2880720" y="1370160"/>
            <a:ext cx="532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acteroidetes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正方形/長方形 23"/>
          <p:cNvSpPr/>
          <p:nvPr/>
        </p:nvSpPr>
        <p:spPr>
          <a:xfrm>
            <a:off x="2197080" y="1434960"/>
            <a:ext cx="14828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thiobacter alkaliphilus 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HT1 (EEG75984)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正方形/長方形 24"/>
          <p:cNvSpPr/>
          <p:nvPr/>
        </p:nvSpPr>
        <p:spPr>
          <a:xfrm>
            <a:off x="2192400" y="1500120"/>
            <a:ext cx="18540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lusimicrobia bacterium RIFOXYA2 FULL 40 6 OGS2098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正方形/長方形 25"/>
          <p:cNvSpPr/>
          <p:nvPr/>
        </p:nvSpPr>
        <p:spPr>
          <a:xfrm>
            <a:off x="2224080" y="1565280"/>
            <a:ext cx="18543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opsychrobacter electrodiphilus 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SM16401 (2522771243)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正方形/長方形 26"/>
          <p:cNvSpPr/>
          <p:nvPr/>
        </p:nvSpPr>
        <p:spPr>
          <a:xfrm>
            <a:off x="2221920" y="1636560"/>
            <a:ext cx="1242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lostridium tunisiense 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J WP08386172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正方形/長方形 27"/>
          <p:cNvSpPr/>
          <p:nvPr/>
        </p:nvSpPr>
        <p:spPr>
          <a:xfrm>
            <a:off x="2874960" y="1695600"/>
            <a:ext cx="5097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pirochaetes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正方形/長方形 28"/>
          <p:cNvSpPr/>
          <p:nvPr/>
        </p:nvSpPr>
        <p:spPr>
          <a:xfrm>
            <a:off x="2181240" y="1766880"/>
            <a:ext cx="1650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nclassified PVC group bacterium Bin55r1 Ga0224692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正方形/長方形 29"/>
          <p:cNvSpPr/>
          <p:nvPr/>
        </p:nvSpPr>
        <p:spPr>
          <a:xfrm>
            <a:off x="2875680" y="1830240"/>
            <a:ext cx="5634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sulfomonile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正方形/長方形 31"/>
          <p:cNvSpPr/>
          <p:nvPr/>
        </p:nvSpPr>
        <p:spPr>
          <a:xfrm>
            <a:off x="2276640" y="2282760"/>
            <a:ext cx="1433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lostridium litorale 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SM5388 WP038261074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正方形/長方形 32"/>
          <p:cNvSpPr/>
          <p:nvPr/>
        </p:nvSpPr>
        <p:spPr>
          <a:xfrm>
            <a:off x="2273040" y="1892160"/>
            <a:ext cx="1310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lta proteobacterium NaphS2 (EFK05860)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正方形/長方形 33"/>
          <p:cNvSpPr/>
          <p:nvPr/>
        </p:nvSpPr>
        <p:spPr>
          <a:xfrm>
            <a:off x="2276640" y="1960560"/>
            <a:ext cx="12474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itrospira bacterium SG8 3 2 KPK25307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正方形/長方形 34"/>
          <p:cNvSpPr/>
          <p:nvPr/>
        </p:nvSpPr>
        <p:spPr>
          <a:xfrm>
            <a:off x="2239920" y="2023920"/>
            <a:ext cx="13082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cetonema longum 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SM6540 (EGO62460)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正方形/長方形 35"/>
          <p:cNvSpPr/>
          <p:nvPr/>
        </p:nvSpPr>
        <p:spPr>
          <a:xfrm>
            <a:off x="2219400" y="2089080"/>
            <a:ext cx="15570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nclassified Aminicenantes OP8 Bin144 Ga020719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正方形/長方形 36"/>
          <p:cNvSpPr/>
          <p:nvPr/>
        </p:nvSpPr>
        <p:spPr>
          <a:xfrm>
            <a:off x="2252520" y="2151000"/>
            <a:ext cx="18342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entisphaerae bacterium RIFOXYA12 FULL 48 11 OGV64894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正方形/長方形 37"/>
          <p:cNvSpPr/>
          <p:nvPr/>
        </p:nvSpPr>
        <p:spPr>
          <a:xfrm>
            <a:off x="2323080" y="2216160"/>
            <a:ext cx="14594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halococcoides mccartyi 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CMB5 (AGG05960)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正方形/長方形 38"/>
          <p:cNvSpPr/>
          <p:nvPr/>
        </p:nvSpPr>
        <p:spPr>
          <a:xfrm>
            <a:off x="2168640" y="2343240"/>
            <a:ext cx="1322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sulfuromonas soudanensis 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LC17222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正方形/長方形 39"/>
          <p:cNvSpPr/>
          <p:nvPr/>
        </p:nvSpPr>
        <p:spPr>
          <a:xfrm>
            <a:off x="2873880" y="2409840"/>
            <a:ext cx="11073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ltaproteobacteria (Desulfovibrio)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正方形/長方形 40"/>
          <p:cNvSpPr/>
          <p:nvPr/>
        </p:nvSpPr>
        <p:spPr>
          <a:xfrm>
            <a:off x="2879640" y="2482920"/>
            <a:ext cx="13176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ltaproteobacteria (Geobacter)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正方形/長方形 41"/>
          <p:cNvSpPr/>
          <p:nvPr/>
        </p:nvSpPr>
        <p:spPr>
          <a:xfrm>
            <a:off x="2257560" y="2684520"/>
            <a:ext cx="14713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itrospirae bacterium GWC2 56 14 OGW34102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正方形/長方形 42"/>
          <p:cNvSpPr/>
          <p:nvPr/>
        </p:nvSpPr>
        <p:spPr>
          <a:xfrm>
            <a:off x="2247120" y="2548080"/>
            <a:ext cx="1323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obacter uraniireducens 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f4 (ABQ24696)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正方形/長方形 43"/>
          <p:cNvSpPr/>
          <p:nvPr/>
        </p:nvSpPr>
        <p:spPr>
          <a:xfrm>
            <a:off x="2248560" y="2611440"/>
            <a:ext cx="12351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obacter daltonii 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RC32 (ACM20835)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正方形/長方形 44"/>
          <p:cNvSpPr/>
          <p:nvPr/>
        </p:nvSpPr>
        <p:spPr>
          <a:xfrm>
            <a:off x="2873520" y="2744640"/>
            <a:ext cx="13176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ltaproteobacteria (Geobacter)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正方形/長方形 45"/>
          <p:cNvSpPr/>
          <p:nvPr/>
        </p:nvSpPr>
        <p:spPr>
          <a:xfrm>
            <a:off x="2873880" y="2813040"/>
            <a:ext cx="11073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ltaproteobacteria (Desulfovibrio)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正方形/長方形 46"/>
          <p:cNvSpPr/>
          <p:nvPr/>
        </p:nvSpPr>
        <p:spPr>
          <a:xfrm>
            <a:off x="2874240" y="3021120"/>
            <a:ext cx="17046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ltaproteobacteria (Desulfomicrobium/Desulfonatronum)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正方形/長方形 47"/>
          <p:cNvSpPr/>
          <p:nvPr/>
        </p:nvSpPr>
        <p:spPr>
          <a:xfrm>
            <a:off x="2875680" y="2881440"/>
            <a:ext cx="2264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ltaproteobacteria (Desulfospira/Desulfobacula/Desulfotignum/Desulfobulbus)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正方形/長方形 48"/>
          <p:cNvSpPr/>
          <p:nvPr/>
        </p:nvSpPr>
        <p:spPr>
          <a:xfrm>
            <a:off x="2877840" y="2954160"/>
            <a:ext cx="2440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ltaproteobacteria (Desulfovibrio/Pseudodesulfovibrio/Desulfococcus/Desulfobulbus)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正方形/長方形 49"/>
          <p:cNvSpPr/>
          <p:nvPr/>
        </p:nvSpPr>
        <p:spPr>
          <a:xfrm>
            <a:off x="2286000" y="3281400"/>
            <a:ext cx="1574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lkalispirochaeta odontotermitis 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P037564333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正方形/長方形 50"/>
          <p:cNvSpPr/>
          <p:nvPr/>
        </p:nvSpPr>
        <p:spPr>
          <a:xfrm>
            <a:off x="2269440" y="3084480"/>
            <a:ext cx="1492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sulfovibrio oxyclinae 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SM11498 (2515862844)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正方形/長方形 51"/>
          <p:cNvSpPr/>
          <p:nvPr/>
        </p:nvSpPr>
        <p:spPr>
          <a:xfrm>
            <a:off x="2266920" y="3154320"/>
            <a:ext cx="1515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sulfovibrio inopinatus 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SM10711 (2525213937)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正方形/長方形 52"/>
          <p:cNvSpPr/>
          <p:nvPr/>
        </p:nvSpPr>
        <p:spPr>
          <a:xfrm>
            <a:off x="2282760" y="3218040"/>
            <a:ext cx="12474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itrospira bacterium SG8 3 2 KPK34758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正方形/長方形 53"/>
          <p:cNvSpPr/>
          <p:nvPr/>
        </p:nvSpPr>
        <p:spPr>
          <a:xfrm>
            <a:off x="2885040" y="3346560"/>
            <a:ext cx="503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uryarchae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正方形/長方形 54"/>
          <p:cNvSpPr/>
          <p:nvPr/>
        </p:nvSpPr>
        <p:spPr>
          <a:xfrm>
            <a:off x="2274840" y="3483000"/>
            <a:ext cx="16336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and division OP9 SCGC AAA255 N14 2265072414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正方形/長方形 55"/>
          <p:cNvSpPr/>
          <p:nvPr/>
        </p:nvSpPr>
        <p:spPr>
          <a:xfrm>
            <a:off x="2887920" y="3419640"/>
            <a:ext cx="532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acteroidetes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正方形/長方形 56"/>
          <p:cNvSpPr/>
          <p:nvPr/>
        </p:nvSpPr>
        <p:spPr>
          <a:xfrm>
            <a:off x="2246400" y="3549600"/>
            <a:ext cx="162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ethanomassiliicoccus luminyensis 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10 (2518907383)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正方形/長方形 57"/>
          <p:cNvSpPr/>
          <p:nvPr/>
        </p:nvSpPr>
        <p:spPr>
          <a:xfrm>
            <a:off x="2870280" y="3614760"/>
            <a:ext cx="1326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yntrophus aciditrophicus 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B (ABC78805)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正方形/長方形 58"/>
          <p:cNvSpPr/>
          <p:nvPr/>
        </p:nvSpPr>
        <p:spPr>
          <a:xfrm>
            <a:off x="2895480" y="3686040"/>
            <a:ext cx="503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uryarchae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正方形/長方形 59"/>
          <p:cNvSpPr/>
          <p:nvPr/>
        </p:nvSpPr>
        <p:spPr>
          <a:xfrm>
            <a:off x="2898720" y="3763800"/>
            <a:ext cx="5097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pirochaetes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正方形/長方形 61"/>
          <p:cNvSpPr/>
          <p:nvPr/>
        </p:nvSpPr>
        <p:spPr>
          <a:xfrm>
            <a:off x="2195640" y="3960720"/>
            <a:ext cx="162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nclassified Spirochaetes Bin180 Ga0224672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正方形/長方形 62"/>
          <p:cNvSpPr/>
          <p:nvPr/>
        </p:nvSpPr>
        <p:spPr>
          <a:xfrm>
            <a:off x="2084400" y="3832200"/>
            <a:ext cx="11836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eponema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p GWA1 62 8 OHE6604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正方形/長方形 63"/>
          <p:cNvSpPr/>
          <p:nvPr/>
        </p:nvSpPr>
        <p:spPr>
          <a:xfrm>
            <a:off x="2236320" y="3894120"/>
            <a:ext cx="10785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rysiogenes arsenatis 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FH4242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正方形/長方形 64"/>
          <p:cNvSpPr/>
          <p:nvPr/>
        </p:nvSpPr>
        <p:spPr>
          <a:xfrm>
            <a:off x="2066760" y="4025880"/>
            <a:ext cx="1360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lta proteobacterium MLMS1 (639154018)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正方形/長方形 65"/>
          <p:cNvSpPr/>
          <p:nvPr/>
        </p:nvSpPr>
        <p:spPr>
          <a:xfrm>
            <a:off x="2347920" y="4278240"/>
            <a:ext cx="11350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1 800m final contigs 819425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正方形/長方形 66"/>
          <p:cNvSpPr/>
          <p:nvPr/>
        </p:nvSpPr>
        <p:spPr>
          <a:xfrm>
            <a:off x="2369520" y="4079880"/>
            <a:ext cx="1022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0 800m final contigs 570684 c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正方形/長方形 67"/>
          <p:cNvSpPr/>
          <p:nvPr/>
        </p:nvSpPr>
        <p:spPr>
          <a:xfrm>
            <a:off x="2372040" y="4140360"/>
            <a:ext cx="1056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1 800m final contigs 1294085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正方形/長方形 68"/>
          <p:cNvSpPr/>
          <p:nvPr/>
        </p:nvSpPr>
        <p:spPr>
          <a:xfrm>
            <a:off x="2339640" y="4206960"/>
            <a:ext cx="1024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1 800m final contigs 783384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正方形/長方形 69"/>
          <p:cNvSpPr/>
          <p:nvPr/>
        </p:nvSpPr>
        <p:spPr>
          <a:xfrm>
            <a:off x="2427120" y="4538520"/>
            <a:ext cx="1063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0 800m final contigs 931895 c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正方形/長方形 1"/>
          <p:cNvSpPr/>
          <p:nvPr/>
        </p:nvSpPr>
        <p:spPr>
          <a:xfrm>
            <a:off x="2426760" y="4341960"/>
            <a:ext cx="1056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0 500m final contigs 1375726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正方形/長方形 2"/>
          <p:cNvSpPr/>
          <p:nvPr/>
        </p:nvSpPr>
        <p:spPr>
          <a:xfrm>
            <a:off x="2426760" y="4405320"/>
            <a:ext cx="1024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1 500m final contigs 823744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正方形/長方形 3"/>
          <p:cNvSpPr/>
          <p:nvPr/>
        </p:nvSpPr>
        <p:spPr>
          <a:xfrm>
            <a:off x="2426400" y="4471920"/>
            <a:ext cx="9608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1 800m final contigs 6449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正方形/長方形 4"/>
          <p:cNvSpPr/>
          <p:nvPr/>
        </p:nvSpPr>
        <p:spPr>
          <a:xfrm>
            <a:off x="2046240" y="4925880"/>
            <a:ext cx="1125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1 800m final contigs 326219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0" name="正方形/長方形 7"/>
          <p:cNvSpPr/>
          <p:nvPr/>
        </p:nvSpPr>
        <p:spPr>
          <a:xfrm>
            <a:off x="2288160" y="4603680"/>
            <a:ext cx="1024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1 500m final contigs 234401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正方形/長方形 30"/>
          <p:cNvSpPr/>
          <p:nvPr/>
        </p:nvSpPr>
        <p:spPr>
          <a:xfrm>
            <a:off x="2124360" y="4664160"/>
            <a:ext cx="1024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0 500m final contigs 174278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正方形/長方形 60"/>
          <p:cNvSpPr/>
          <p:nvPr/>
        </p:nvSpPr>
        <p:spPr>
          <a:xfrm>
            <a:off x="2088720" y="4732200"/>
            <a:ext cx="1024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0 800m final contigs 483828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正方形/長方形 70"/>
          <p:cNvSpPr/>
          <p:nvPr/>
        </p:nvSpPr>
        <p:spPr>
          <a:xfrm>
            <a:off x="2116440" y="4794120"/>
            <a:ext cx="1022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0 800m final contigs 973745 c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正方形/長方形 71"/>
          <p:cNvSpPr/>
          <p:nvPr/>
        </p:nvSpPr>
        <p:spPr>
          <a:xfrm>
            <a:off x="2119320" y="4856040"/>
            <a:ext cx="1022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1 800m final contigs 412220 c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正方形/長方形 72"/>
          <p:cNvSpPr/>
          <p:nvPr/>
        </p:nvSpPr>
        <p:spPr>
          <a:xfrm>
            <a:off x="2604960" y="5310360"/>
            <a:ext cx="10861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0 800m final contigs 279382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正方形/長方形 73"/>
          <p:cNvSpPr/>
          <p:nvPr/>
        </p:nvSpPr>
        <p:spPr>
          <a:xfrm>
            <a:off x="2634840" y="4991040"/>
            <a:ext cx="1024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0 800m final contigs 623258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正方形/長方形 74"/>
          <p:cNvSpPr/>
          <p:nvPr/>
        </p:nvSpPr>
        <p:spPr>
          <a:xfrm>
            <a:off x="2634840" y="5054760"/>
            <a:ext cx="1056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1 800m final contigs 1380626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正方形/長方形 75"/>
          <p:cNvSpPr/>
          <p:nvPr/>
        </p:nvSpPr>
        <p:spPr>
          <a:xfrm>
            <a:off x="2624760" y="5118120"/>
            <a:ext cx="1024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0 800m final contigs 930920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正方形/長方形 76"/>
          <p:cNvSpPr/>
          <p:nvPr/>
        </p:nvSpPr>
        <p:spPr>
          <a:xfrm>
            <a:off x="2625480" y="5180040"/>
            <a:ext cx="1024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0 500m final contigs 865608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正方形/長方形 77"/>
          <p:cNvSpPr/>
          <p:nvPr/>
        </p:nvSpPr>
        <p:spPr>
          <a:xfrm>
            <a:off x="2636640" y="5243400"/>
            <a:ext cx="1024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1 800m final contigs 573281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正方形/長方形 78"/>
          <p:cNvSpPr/>
          <p:nvPr/>
        </p:nvSpPr>
        <p:spPr>
          <a:xfrm>
            <a:off x="2122560" y="5370480"/>
            <a:ext cx="11970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1 500m final contigs 750763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2" name="正方形/長方形 79"/>
          <p:cNvSpPr/>
          <p:nvPr/>
        </p:nvSpPr>
        <p:spPr>
          <a:xfrm>
            <a:off x="2016000" y="7356600"/>
            <a:ext cx="16858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sulfonatronospira thiodismutans 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O31 (EFI33705)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正方形/長方形 80"/>
          <p:cNvSpPr/>
          <p:nvPr/>
        </p:nvSpPr>
        <p:spPr>
          <a:xfrm>
            <a:off x="2179800" y="5437080"/>
            <a:ext cx="11048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0 500m final contigs 996778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正方形/長方形 81"/>
          <p:cNvSpPr/>
          <p:nvPr/>
        </p:nvSpPr>
        <p:spPr>
          <a:xfrm>
            <a:off x="2193840" y="5880240"/>
            <a:ext cx="11494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1 500m final contigs 1015852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5" name="正方形/長方形 82"/>
          <p:cNvSpPr/>
          <p:nvPr/>
        </p:nvSpPr>
        <p:spPr>
          <a:xfrm>
            <a:off x="2259360" y="5495760"/>
            <a:ext cx="957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0 800m final contigs 8356 c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正方形/長方形 83"/>
          <p:cNvSpPr/>
          <p:nvPr/>
        </p:nvSpPr>
        <p:spPr>
          <a:xfrm>
            <a:off x="2264760" y="5560920"/>
            <a:ext cx="10540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1 500m final contigs 1752096 c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正方形/長方形 84"/>
          <p:cNvSpPr/>
          <p:nvPr/>
        </p:nvSpPr>
        <p:spPr>
          <a:xfrm>
            <a:off x="2268720" y="5626080"/>
            <a:ext cx="1022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0 500m final contigs 615175 c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正方形/長方形 85"/>
          <p:cNvSpPr/>
          <p:nvPr/>
        </p:nvSpPr>
        <p:spPr>
          <a:xfrm>
            <a:off x="2268720" y="5691240"/>
            <a:ext cx="1022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1 800m final contigs 975630 c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正方形/長方形 86"/>
          <p:cNvSpPr/>
          <p:nvPr/>
        </p:nvSpPr>
        <p:spPr>
          <a:xfrm>
            <a:off x="2272680" y="5754600"/>
            <a:ext cx="10540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0 800m final contigs 1544867 c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正方形/長方形 87"/>
          <p:cNvSpPr/>
          <p:nvPr/>
        </p:nvSpPr>
        <p:spPr>
          <a:xfrm>
            <a:off x="2258280" y="5819760"/>
            <a:ext cx="10540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1 800m final contigs 1589937 c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正方形/長方形 88"/>
          <p:cNvSpPr/>
          <p:nvPr/>
        </p:nvSpPr>
        <p:spPr>
          <a:xfrm>
            <a:off x="2217600" y="7292880"/>
            <a:ext cx="11653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0 500m final contigs 1938440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2" name="正方形/長方形 89"/>
          <p:cNvSpPr/>
          <p:nvPr/>
        </p:nvSpPr>
        <p:spPr>
          <a:xfrm>
            <a:off x="2227680" y="6845400"/>
            <a:ext cx="1024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1 500m final contigs 888841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正方形/長方形 90"/>
          <p:cNvSpPr/>
          <p:nvPr/>
        </p:nvSpPr>
        <p:spPr>
          <a:xfrm>
            <a:off x="2227680" y="6908760"/>
            <a:ext cx="1024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0 500m final contigs 461124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4" name="正方形/長方形 91"/>
          <p:cNvSpPr/>
          <p:nvPr/>
        </p:nvSpPr>
        <p:spPr>
          <a:xfrm>
            <a:off x="2223360" y="6973920"/>
            <a:ext cx="1056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0 500m final contigs 1551885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正方形/長方形 92"/>
          <p:cNvSpPr/>
          <p:nvPr/>
        </p:nvSpPr>
        <p:spPr>
          <a:xfrm>
            <a:off x="2213280" y="7037280"/>
            <a:ext cx="10540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0 800m final contigs 1104905 c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正方形/長方形 93"/>
          <p:cNvSpPr/>
          <p:nvPr/>
        </p:nvSpPr>
        <p:spPr>
          <a:xfrm>
            <a:off x="2206080" y="7101000"/>
            <a:ext cx="1056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0 500m final contigs 1348822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7" name="正方形/長方形 94"/>
          <p:cNvSpPr/>
          <p:nvPr/>
        </p:nvSpPr>
        <p:spPr>
          <a:xfrm>
            <a:off x="2223000" y="7164360"/>
            <a:ext cx="1024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1 500m final contigs 611912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8" name="正方形/長方形 95"/>
          <p:cNvSpPr/>
          <p:nvPr/>
        </p:nvSpPr>
        <p:spPr>
          <a:xfrm>
            <a:off x="2219400" y="7229520"/>
            <a:ext cx="1022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1 500m final contigs 516513 c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" name="正方形/長方形 96"/>
          <p:cNvSpPr/>
          <p:nvPr/>
        </p:nvSpPr>
        <p:spPr>
          <a:xfrm>
            <a:off x="2232000" y="6786720"/>
            <a:ext cx="11113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0 800m final contigs 1754209 c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" name="正方形/長方形 97"/>
          <p:cNvSpPr/>
          <p:nvPr/>
        </p:nvSpPr>
        <p:spPr>
          <a:xfrm>
            <a:off x="2226600" y="5945040"/>
            <a:ext cx="1034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itrospina HgcB (fig|1131269.3)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正方形/長方形 98"/>
          <p:cNvSpPr/>
          <p:nvPr/>
        </p:nvSpPr>
        <p:spPr>
          <a:xfrm>
            <a:off x="2224800" y="6008760"/>
            <a:ext cx="10540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1 800m final contigs 1282867 c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正方形/長方形 99"/>
          <p:cNvSpPr/>
          <p:nvPr/>
        </p:nvSpPr>
        <p:spPr>
          <a:xfrm>
            <a:off x="2229840" y="6073920"/>
            <a:ext cx="1056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1 500m final contigs 1352571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3" name="正方形/長方形 100"/>
          <p:cNvSpPr/>
          <p:nvPr/>
        </p:nvSpPr>
        <p:spPr>
          <a:xfrm>
            <a:off x="2236320" y="6138720"/>
            <a:ext cx="1056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0 800m final contigs 1707418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正方形/長方形 101"/>
          <p:cNvSpPr/>
          <p:nvPr/>
        </p:nvSpPr>
        <p:spPr>
          <a:xfrm>
            <a:off x="2239200" y="6203880"/>
            <a:ext cx="10540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1 500m final contigs 1609826 c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正方形/長方形 102"/>
          <p:cNvSpPr/>
          <p:nvPr/>
        </p:nvSpPr>
        <p:spPr>
          <a:xfrm>
            <a:off x="2239560" y="6269040"/>
            <a:ext cx="1056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0 800m final contigs 1604307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正方形/長方形 103"/>
          <p:cNvSpPr/>
          <p:nvPr/>
        </p:nvSpPr>
        <p:spPr>
          <a:xfrm>
            <a:off x="2237760" y="6332400"/>
            <a:ext cx="1056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0 500m final contigs 1269042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7" name="正方形/長方形 104"/>
          <p:cNvSpPr/>
          <p:nvPr/>
        </p:nvSpPr>
        <p:spPr>
          <a:xfrm>
            <a:off x="2244960" y="6397560"/>
            <a:ext cx="1056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0 800m final contigs 1139891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8" name="正方形/長方形 105"/>
          <p:cNvSpPr/>
          <p:nvPr/>
        </p:nvSpPr>
        <p:spPr>
          <a:xfrm>
            <a:off x="2235240" y="6462720"/>
            <a:ext cx="1056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0 500m final contigs 1812087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9" name="正方形/長方形 106"/>
          <p:cNvSpPr/>
          <p:nvPr/>
        </p:nvSpPr>
        <p:spPr>
          <a:xfrm>
            <a:off x="2239560" y="6527880"/>
            <a:ext cx="9928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0 500m final contigs 35735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正方形/長方形 107"/>
          <p:cNvSpPr/>
          <p:nvPr/>
        </p:nvSpPr>
        <p:spPr>
          <a:xfrm>
            <a:off x="2219760" y="6593040"/>
            <a:ext cx="1024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0 500m final contigs 971917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1" name="正方形/長方形 108"/>
          <p:cNvSpPr/>
          <p:nvPr/>
        </p:nvSpPr>
        <p:spPr>
          <a:xfrm>
            <a:off x="2229120" y="6657840"/>
            <a:ext cx="1056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0 800m final contigs 1373372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正方形/長方形 109"/>
          <p:cNvSpPr/>
          <p:nvPr/>
        </p:nvSpPr>
        <p:spPr>
          <a:xfrm>
            <a:off x="2225160" y="6721560"/>
            <a:ext cx="1024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t1 800m final contigs 783872 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正方形/長方形 110"/>
          <p:cNvSpPr/>
          <p:nvPr/>
        </p:nvSpPr>
        <p:spPr>
          <a:xfrm>
            <a:off x="1582560" y="7532640"/>
            <a:ext cx="2653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.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4" name="直線コネクタ 113"/>
          <p:cNvSpPr/>
          <p:nvPr/>
        </p:nvSpPr>
        <p:spPr>
          <a:xfrm>
            <a:off x="3701880" y="5538960"/>
            <a:ext cx="0" cy="18475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5" name="正方形/長方形 115"/>
          <p:cNvSpPr/>
          <p:nvPr/>
        </p:nvSpPr>
        <p:spPr>
          <a:xfrm>
            <a:off x="2093400" y="32544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5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6" name="正方形/長方形 116"/>
          <p:cNvSpPr/>
          <p:nvPr/>
        </p:nvSpPr>
        <p:spPr>
          <a:xfrm>
            <a:off x="2030040" y="51912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9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7" name="正方形/長方形 117"/>
          <p:cNvSpPr/>
          <p:nvPr/>
        </p:nvSpPr>
        <p:spPr>
          <a:xfrm>
            <a:off x="2117160" y="65736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9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8" name="正方形/長方形 118"/>
          <p:cNvSpPr/>
          <p:nvPr/>
        </p:nvSpPr>
        <p:spPr>
          <a:xfrm>
            <a:off x="2098080" y="85896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6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正方形/長方形 119"/>
          <p:cNvSpPr/>
          <p:nvPr/>
        </p:nvSpPr>
        <p:spPr>
          <a:xfrm>
            <a:off x="2014920" y="79200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5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0" name="正方形/長方形 120"/>
          <p:cNvSpPr/>
          <p:nvPr/>
        </p:nvSpPr>
        <p:spPr>
          <a:xfrm>
            <a:off x="2154600" y="99864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7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1" name="正方形/長方形 121"/>
          <p:cNvSpPr/>
          <p:nvPr/>
        </p:nvSpPr>
        <p:spPr>
          <a:xfrm>
            <a:off x="2127600" y="126684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0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正方形/長方形 122"/>
          <p:cNvSpPr/>
          <p:nvPr/>
        </p:nvSpPr>
        <p:spPr>
          <a:xfrm>
            <a:off x="2033640" y="93672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8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正方形/長方形 123"/>
          <p:cNvSpPr/>
          <p:nvPr/>
        </p:nvSpPr>
        <p:spPr>
          <a:xfrm>
            <a:off x="2157480" y="181620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9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正方形/長方形 124"/>
          <p:cNvSpPr/>
          <p:nvPr/>
        </p:nvSpPr>
        <p:spPr>
          <a:xfrm>
            <a:off x="2108520" y="187308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5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正方形/長方形 125"/>
          <p:cNvSpPr/>
          <p:nvPr/>
        </p:nvSpPr>
        <p:spPr>
          <a:xfrm>
            <a:off x="2127600" y="244332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7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6" name="正方形/長方形 126"/>
          <p:cNvSpPr/>
          <p:nvPr/>
        </p:nvSpPr>
        <p:spPr>
          <a:xfrm>
            <a:off x="2084760" y="250992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7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正方形/長方形 127"/>
          <p:cNvSpPr/>
          <p:nvPr/>
        </p:nvSpPr>
        <p:spPr>
          <a:xfrm>
            <a:off x="2102040" y="263700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5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正方形/長方形 128"/>
          <p:cNvSpPr/>
          <p:nvPr/>
        </p:nvSpPr>
        <p:spPr>
          <a:xfrm>
            <a:off x="2030040" y="257796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8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正方形/長方形 129"/>
          <p:cNvSpPr/>
          <p:nvPr/>
        </p:nvSpPr>
        <p:spPr>
          <a:xfrm>
            <a:off x="2089440" y="275436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2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正方形/長方形 130"/>
          <p:cNvSpPr/>
          <p:nvPr/>
        </p:nvSpPr>
        <p:spPr>
          <a:xfrm>
            <a:off x="2155320" y="278460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3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正方形/長方形 131"/>
          <p:cNvSpPr/>
          <p:nvPr/>
        </p:nvSpPr>
        <p:spPr>
          <a:xfrm>
            <a:off x="2167200" y="298620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5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正方形/長方形 132"/>
          <p:cNvSpPr/>
          <p:nvPr/>
        </p:nvSpPr>
        <p:spPr>
          <a:xfrm>
            <a:off x="2084040" y="330516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6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3" name="正方形/長方形 133"/>
          <p:cNvSpPr/>
          <p:nvPr/>
        </p:nvSpPr>
        <p:spPr>
          <a:xfrm>
            <a:off x="2216520" y="339408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9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正方形/長方形 134"/>
          <p:cNvSpPr/>
          <p:nvPr/>
        </p:nvSpPr>
        <p:spPr>
          <a:xfrm>
            <a:off x="2116440" y="342576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6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5" name="正方形/長方形 135"/>
          <p:cNvSpPr/>
          <p:nvPr/>
        </p:nvSpPr>
        <p:spPr>
          <a:xfrm>
            <a:off x="2030040" y="397188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2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6" name="正方形/長方形 136"/>
          <p:cNvSpPr/>
          <p:nvPr/>
        </p:nvSpPr>
        <p:spPr>
          <a:xfrm>
            <a:off x="2236320" y="409104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5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7" name="正方形/長方形 137"/>
          <p:cNvSpPr/>
          <p:nvPr/>
        </p:nvSpPr>
        <p:spPr>
          <a:xfrm>
            <a:off x="2207880" y="423216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7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8" name="正方形/長方形 138"/>
          <p:cNvSpPr/>
          <p:nvPr/>
        </p:nvSpPr>
        <p:spPr>
          <a:xfrm>
            <a:off x="2241000" y="429588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1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9" name="正方形/長方形 139"/>
          <p:cNvSpPr/>
          <p:nvPr/>
        </p:nvSpPr>
        <p:spPr>
          <a:xfrm>
            <a:off x="2287800" y="435132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2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0" name="正方形/長方形 140"/>
          <p:cNvSpPr/>
          <p:nvPr/>
        </p:nvSpPr>
        <p:spPr>
          <a:xfrm>
            <a:off x="2256840" y="439596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1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正方形/長方形 141"/>
          <p:cNvSpPr/>
          <p:nvPr/>
        </p:nvSpPr>
        <p:spPr>
          <a:xfrm>
            <a:off x="2221920" y="445140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7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正方形/長方形 142"/>
          <p:cNvSpPr/>
          <p:nvPr/>
        </p:nvSpPr>
        <p:spPr>
          <a:xfrm>
            <a:off x="2014920" y="486900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8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正方形/長方形 143"/>
          <p:cNvSpPr/>
          <p:nvPr/>
        </p:nvSpPr>
        <p:spPr>
          <a:xfrm>
            <a:off x="1958400" y="478008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2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" name="正方形/長方形 144"/>
          <p:cNvSpPr/>
          <p:nvPr/>
        </p:nvSpPr>
        <p:spPr>
          <a:xfrm>
            <a:off x="1915560" y="485316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8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" name="正方形/長方形 145"/>
          <p:cNvSpPr/>
          <p:nvPr/>
        </p:nvSpPr>
        <p:spPr>
          <a:xfrm>
            <a:off x="2522880" y="498960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8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" name="正方形/長方形 146"/>
          <p:cNvSpPr/>
          <p:nvPr/>
        </p:nvSpPr>
        <p:spPr>
          <a:xfrm>
            <a:off x="2472120" y="518328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1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" name="正方形/長方形 147"/>
          <p:cNvSpPr/>
          <p:nvPr/>
        </p:nvSpPr>
        <p:spPr>
          <a:xfrm>
            <a:off x="2140200" y="555624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2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8" name="正方形/長方形 148"/>
          <p:cNvSpPr/>
          <p:nvPr/>
        </p:nvSpPr>
        <p:spPr>
          <a:xfrm>
            <a:off x="2120400" y="561024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5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9" name="正方形/長方形 149"/>
          <p:cNvSpPr/>
          <p:nvPr/>
        </p:nvSpPr>
        <p:spPr>
          <a:xfrm>
            <a:off x="2093400" y="567072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2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0" name="正方形/長方形 150"/>
          <p:cNvSpPr/>
          <p:nvPr/>
        </p:nvSpPr>
        <p:spPr>
          <a:xfrm>
            <a:off x="2060640" y="576252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3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1" name="正方形/長方形 151"/>
          <p:cNvSpPr/>
          <p:nvPr/>
        </p:nvSpPr>
        <p:spPr>
          <a:xfrm>
            <a:off x="2154600" y="583416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6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2" name="正方形/長方形 152"/>
          <p:cNvSpPr/>
          <p:nvPr/>
        </p:nvSpPr>
        <p:spPr>
          <a:xfrm>
            <a:off x="2102040" y="659592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1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正方形/長方形 153"/>
          <p:cNvSpPr/>
          <p:nvPr/>
        </p:nvSpPr>
        <p:spPr>
          <a:xfrm>
            <a:off x="2103840" y="678024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9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正方形/長方形 154"/>
          <p:cNvSpPr/>
          <p:nvPr/>
        </p:nvSpPr>
        <p:spPr>
          <a:xfrm>
            <a:off x="2064960" y="686124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1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正方形/長方形 155"/>
          <p:cNvSpPr/>
          <p:nvPr/>
        </p:nvSpPr>
        <p:spPr>
          <a:xfrm>
            <a:off x="2157480" y="681840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9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正方形/長方形 156"/>
          <p:cNvSpPr/>
          <p:nvPr/>
        </p:nvSpPr>
        <p:spPr>
          <a:xfrm>
            <a:off x="2121840" y="688032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4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正方形/長方形 157"/>
          <p:cNvSpPr/>
          <p:nvPr/>
        </p:nvSpPr>
        <p:spPr>
          <a:xfrm>
            <a:off x="2076840" y="704232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3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正方形/長方形 158"/>
          <p:cNvSpPr/>
          <p:nvPr/>
        </p:nvSpPr>
        <p:spPr>
          <a:xfrm>
            <a:off x="2085480" y="713916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3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正方形/長方形 159"/>
          <p:cNvSpPr/>
          <p:nvPr/>
        </p:nvSpPr>
        <p:spPr>
          <a:xfrm>
            <a:off x="2092680" y="720108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5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0" name="正方形/長方形 160"/>
          <p:cNvSpPr/>
          <p:nvPr/>
        </p:nvSpPr>
        <p:spPr>
          <a:xfrm>
            <a:off x="2106720" y="7257960"/>
            <a:ext cx="232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2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1" name="直線コネクタ 212"/>
          <p:cNvSpPr/>
          <p:nvPr/>
        </p:nvSpPr>
        <p:spPr>
          <a:xfrm>
            <a:off x="3932280" y="4165560"/>
            <a:ext cx="0" cy="131436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2" name="テキスト ボックス 213"/>
          <p:cNvSpPr/>
          <p:nvPr/>
        </p:nvSpPr>
        <p:spPr>
          <a:xfrm>
            <a:off x="3932280" y="4716360"/>
            <a:ext cx="7063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Unknow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3" name="テキスト ボックス 162"/>
          <p:cNvSpPr/>
          <p:nvPr/>
        </p:nvSpPr>
        <p:spPr>
          <a:xfrm>
            <a:off x="3718440" y="6262560"/>
            <a:ext cx="959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Nitrospina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(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Nitrospina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-like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4" name="テキスト ボックス 3"/>
          <p:cNvSpPr/>
          <p:nvPr/>
        </p:nvSpPr>
        <p:spPr>
          <a:xfrm>
            <a:off x="396720" y="7670880"/>
            <a:ext cx="606456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7. Maximum likelihood tree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gc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 (A) and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gc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 (B) like sequences detected in the paired-end metagenomes from 500 m and 800 m depth at Sts. 0 and 1. Sequences identified in this study (shown in red) are compared with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gcA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homologues described in previous study (Gilmour et al., 2013; Gionfriddo et al., 2016; Gilmour et al., 2018; Christensen et al., 2019; Jones et al., 2019). Bootstrap values with consensus based on 100 replicates are shown. National Center for Biotechnology Information accession numbers or Integrated Microbial Genomes predicted gene numbers are provided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85" name="グループ化 15"/>
          <p:cNvGrpSpPr/>
          <p:nvPr/>
        </p:nvGrpSpPr>
        <p:grpSpPr>
          <a:xfrm>
            <a:off x="946440" y="360360"/>
            <a:ext cx="4928760" cy="7229520"/>
            <a:chOff x="946440" y="360360"/>
            <a:chExt cx="4928760" cy="7229520"/>
          </a:xfrm>
        </p:grpSpPr>
        <p:pic>
          <p:nvPicPr>
            <p:cNvPr id="286" name="図 13" descr=""/>
            <p:cNvPicPr/>
            <p:nvPr/>
          </p:nvPicPr>
          <p:blipFill>
            <a:blip r:embed="rId1"/>
            <a:stretch/>
          </p:blipFill>
          <p:spPr>
            <a:xfrm>
              <a:off x="1745640" y="4209480"/>
              <a:ext cx="3433680" cy="3380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87" name="図 7" descr=""/>
            <p:cNvPicPr/>
            <p:nvPr/>
          </p:nvPicPr>
          <p:blipFill>
            <a:blip r:embed="rId2"/>
            <a:stretch/>
          </p:blipFill>
          <p:spPr>
            <a:xfrm>
              <a:off x="1850040" y="464400"/>
              <a:ext cx="3552840" cy="3580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88" name="テキスト ボックス 10"/>
            <p:cNvSpPr/>
            <p:nvPr/>
          </p:nvSpPr>
          <p:spPr>
            <a:xfrm>
              <a:off x="1796400" y="360360"/>
              <a:ext cx="3758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A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9" name="テキスト ボックス 11"/>
            <p:cNvSpPr/>
            <p:nvPr/>
          </p:nvSpPr>
          <p:spPr>
            <a:xfrm>
              <a:off x="1801080" y="4289400"/>
              <a:ext cx="368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B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0" name="円弧 16"/>
            <p:cNvSpPr/>
            <p:nvPr/>
          </p:nvSpPr>
          <p:spPr>
            <a:xfrm>
              <a:off x="1830240" y="4173480"/>
              <a:ext cx="3365640" cy="3289320"/>
            </a:xfrm>
            <a:custGeom>
              <a:avLst/>
              <a:gdLst/>
              <a:ahLst/>
              <a:rect l="l" t="t" r="r" b="b"/>
              <a:pathLst>
                <a:path stroke="0" w="3366110" h="3289173">
                  <a:moveTo>
                    <a:pt x="1788605" y="3237"/>
                  </a:moveTo>
                  <a:cubicBezTo>
                    <a:pt x="2713928" y="60053"/>
                    <a:pt x="3417964" y="837411"/>
                    <a:pt x="3363168" y="1741785"/>
                  </a:cubicBezTo>
                  <a:lnTo>
                    <a:pt x="1683055" y="1644587"/>
                  </a:lnTo>
                  <a:lnTo>
                    <a:pt x="1788605" y="3237"/>
                  </a:lnTo>
                  <a:close/>
                </a:path>
                <a:path fill="none" w="3366110" h="3289173">
                  <a:moveTo>
                    <a:pt x="1788605" y="3237"/>
                  </a:moveTo>
                  <a:cubicBezTo>
                    <a:pt x="2713928" y="60053"/>
                    <a:pt x="3417964" y="837411"/>
                    <a:pt x="3363168" y="1741785"/>
                  </a:cubicBezTo>
                </a:path>
              </a:pathLst>
            </a:cu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1" name="円弧 23"/>
            <p:cNvSpPr/>
            <p:nvPr/>
          </p:nvSpPr>
          <p:spPr>
            <a:xfrm>
              <a:off x="1830240" y="4173480"/>
              <a:ext cx="3365640" cy="3289320"/>
            </a:xfrm>
            <a:custGeom>
              <a:avLst/>
              <a:gdLst/>
              <a:ahLst/>
              <a:rect l="l" t="t" r="r" b="b"/>
              <a:pathLst>
                <a:path stroke="0" w="3366110" h="3289173">
                  <a:moveTo>
                    <a:pt x="3360321" y="1780876"/>
                  </a:moveTo>
                  <a:cubicBezTo>
                    <a:pt x="3333664" y="2094111"/>
                    <a:pt x="3215703" y="2393321"/>
                    <a:pt x="3020406" y="2643076"/>
                  </a:cubicBezTo>
                  <a:lnTo>
                    <a:pt x="1683055" y="1644587"/>
                  </a:lnTo>
                  <a:lnTo>
                    <a:pt x="3360321" y="1780876"/>
                  </a:lnTo>
                  <a:close/>
                </a:path>
                <a:path fill="none" w="3366110" h="3289173">
                  <a:moveTo>
                    <a:pt x="3360321" y="1780876"/>
                  </a:moveTo>
                  <a:cubicBezTo>
                    <a:pt x="3333664" y="2094111"/>
                    <a:pt x="3215703" y="2393321"/>
                    <a:pt x="3020406" y="2643076"/>
                  </a:cubicBezTo>
                </a:path>
              </a:pathLst>
            </a:cu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2" name="円弧 24"/>
            <p:cNvSpPr/>
            <p:nvPr/>
          </p:nvSpPr>
          <p:spPr>
            <a:xfrm>
              <a:off x="1830240" y="4173480"/>
              <a:ext cx="3365640" cy="3289320"/>
            </a:xfrm>
            <a:custGeom>
              <a:avLst/>
              <a:gdLst/>
              <a:ahLst/>
              <a:rect l="l" t="t" r="r" b="b"/>
              <a:pathLst>
                <a:path stroke="0" w="3366110" h="3289173">
                  <a:moveTo>
                    <a:pt x="2947004" y="2730539"/>
                  </a:moveTo>
                  <a:cubicBezTo>
                    <a:pt x="2877122" y="2808200"/>
                    <a:pt x="2799899" y="2879247"/>
                    <a:pt x="2716362" y="2942736"/>
                  </a:cubicBezTo>
                  <a:lnTo>
                    <a:pt x="1683055" y="1644587"/>
                  </a:lnTo>
                  <a:lnTo>
                    <a:pt x="2947004" y="2730539"/>
                  </a:lnTo>
                  <a:close/>
                </a:path>
                <a:path fill="none" w="3366110" h="3289173">
                  <a:moveTo>
                    <a:pt x="2947004" y="2730539"/>
                  </a:moveTo>
                  <a:cubicBezTo>
                    <a:pt x="2877122" y="2808200"/>
                    <a:pt x="2799899" y="2879247"/>
                    <a:pt x="2716362" y="2942736"/>
                  </a:cubicBezTo>
                </a:path>
              </a:pathLst>
            </a:cu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3" name="テキスト ボックス 21"/>
            <p:cNvSpPr/>
            <p:nvPr/>
          </p:nvSpPr>
          <p:spPr>
            <a:xfrm>
              <a:off x="5065920" y="6363360"/>
              <a:ext cx="730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Arial Unicode MS"/>
                </a:rPr>
                <a:t>Unknown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4" name="テキスト ボックス 22"/>
            <p:cNvSpPr/>
            <p:nvPr/>
          </p:nvSpPr>
          <p:spPr>
            <a:xfrm>
              <a:off x="4631400" y="7012800"/>
              <a:ext cx="1243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Arial Unicode MS"/>
                </a:rPr>
                <a:t>Deltaproteobacteria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Arial Unicode MS"/>
                </a:rPr>
                <a:t>(</a:t>
              </a:r>
              <a:r>
                <a:rPr b="0" i="1" lang="en-US" sz="900" spc="-1" strike="noStrike">
                  <a:solidFill>
                    <a:srgbClr val="000000"/>
                  </a:solidFill>
                  <a:latin typeface="Times New Roman"/>
                  <a:ea typeface="Arial Unicode MS"/>
                </a:rPr>
                <a:t>Syntrophus</a:t>
              </a: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Arial Unicode MS"/>
                </a:rPr>
                <a:t>-like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5" name="円弧 25"/>
            <p:cNvSpPr/>
            <p:nvPr/>
          </p:nvSpPr>
          <p:spPr>
            <a:xfrm>
              <a:off x="1753920" y="601560"/>
              <a:ext cx="3365640" cy="3289320"/>
            </a:xfrm>
            <a:custGeom>
              <a:avLst/>
              <a:gdLst/>
              <a:ahLst/>
              <a:rect l="l" t="t" r="r" b="b"/>
              <a:pathLst>
                <a:path stroke="0" w="3366110" h="3289173">
                  <a:moveTo>
                    <a:pt x="345310" y="2642571"/>
                  </a:moveTo>
                  <a:cubicBezTo>
                    <a:pt x="-142117" y="2018727"/>
                    <a:pt x="-110470" y="1145261"/>
                    <a:pt x="420885" y="556661"/>
                  </a:cubicBezTo>
                  <a:lnTo>
                    <a:pt x="1683055" y="1644587"/>
                  </a:lnTo>
                  <a:lnTo>
                    <a:pt x="345310" y="2642571"/>
                  </a:lnTo>
                  <a:close/>
                </a:path>
                <a:path fill="none" w="3366110" h="3289173">
                  <a:moveTo>
                    <a:pt x="345310" y="2642571"/>
                  </a:moveTo>
                  <a:cubicBezTo>
                    <a:pt x="-142117" y="2018727"/>
                    <a:pt x="-110470" y="1145261"/>
                    <a:pt x="420885" y="556661"/>
                  </a:cubicBezTo>
                </a:path>
              </a:pathLst>
            </a:cu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6" name="円弧 26"/>
            <p:cNvSpPr/>
            <p:nvPr/>
          </p:nvSpPr>
          <p:spPr>
            <a:xfrm>
              <a:off x="1753920" y="601560"/>
              <a:ext cx="3365640" cy="3289320"/>
            </a:xfrm>
            <a:custGeom>
              <a:avLst/>
              <a:gdLst/>
              <a:ahLst/>
              <a:rect l="l" t="t" r="r" b="b"/>
              <a:pathLst>
                <a:path stroke="0" w="3366110" h="3289173">
                  <a:moveTo>
                    <a:pt x="1019747" y="3156066"/>
                  </a:moveTo>
                  <a:cubicBezTo>
                    <a:pt x="779048" y="3055209"/>
                    <a:pt x="565758" y="2900857"/>
                    <a:pt x="396845" y="2705288"/>
                  </a:cubicBezTo>
                  <a:lnTo>
                    <a:pt x="1683055" y="1644587"/>
                  </a:lnTo>
                  <a:lnTo>
                    <a:pt x="1019747" y="3156066"/>
                  </a:lnTo>
                  <a:close/>
                </a:path>
                <a:path fill="none" w="3366110" h="3289173">
                  <a:moveTo>
                    <a:pt x="1019747" y="3156066"/>
                  </a:moveTo>
                  <a:cubicBezTo>
                    <a:pt x="779048" y="3055209"/>
                    <a:pt x="565758" y="2900857"/>
                    <a:pt x="396845" y="2705288"/>
                  </a:cubicBezTo>
                </a:path>
              </a:pathLst>
            </a:cu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7" name="円弧 27"/>
            <p:cNvSpPr/>
            <p:nvPr/>
          </p:nvSpPr>
          <p:spPr>
            <a:xfrm>
              <a:off x="1753920" y="601560"/>
              <a:ext cx="3365640" cy="3289320"/>
            </a:xfrm>
            <a:custGeom>
              <a:avLst/>
              <a:gdLst/>
              <a:ahLst/>
              <a:rect l="l" t="t" r="r" b="b"/>
              <a:pathLst>
                <a:path stroke="0" w="3366110" h="3289173">
                  <a:moveTo>
                    <a:pt x="521936" y="454044"/>
                  </a:moveTo>
                  <a:cubicBezTo>
                    <a:pt x="567305" y="411796"/>
                    <a:pt x="615054" y="372057"/>
                    <a:pt x="664959" y="335013"/>
                  </a:cubicBezTo>
                  <a:lnTo>
                    <a:pt x="1683055" y="1644587"/>
                  </a:lnTo>
                  <a:lnTo>
                    <a:pt x="521936" y="454044"/>
                  </a:lnTo>
                  <a:close/>
                </a:path>
                <a:path fill="none" w="3366110" h="3289173">
                  <a:moveTo>
                    <a:pt x="521936" y="454044"/>
                  </a:moveTo>
                  <a:cubicBezTo>
                    <a:pt x="567305" y="411796"/>
                    <a:pt x="615054" y="372057"/>
                    <a:pt x="664959" y="335013"/>
                  </a:cubicBezTo>
                </a:path>
              </a:pathLst>
            </a:cu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8" name="テキスト ボックス 28"/>
            <p:cNvSpPr/>
            <p:nvPr/>
          </p:nvSpPr>
          <p:spPr>
            <a:xfrm>
              <a:off x="1812600" y="3495240"/>
              <a:ext cx="730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Arial Unicode MS"/>
                </a:rPr>
                <a:t>Unknown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9" name="テキスト ボックス 29"/>
            <p:cNvSpPr/>
            <p:nvPr/>
          </p:nvSpPr>
          <p:spPr>
            <a:xfrm>
              <a:off x="1128600" y="617040"/>
              <a:ext cx="1249920" cy="505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hloroflexi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</a:t>
              </a:r>
              <a:r>
                <a:rPr b="0" i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ehalococcoidia</a:t>
              </a: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Arial Unicode MS"/>
                </a:rPr>
                <a:t>-like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0" name="テキスト ボックス 20"/>
            <p:cNvSpPr/>
            <p:nvPr/>
          </p:nvSpPr>
          <p:spPr>
            <a:xfrm>
              <a:off x="4915440" y="4616280"/>
              <a:ext cx="959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Arial Unicode MS"/>
                </a:rPr>
                <a:t>Nitrospinae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Arial Unicode MS"/>
                </a:rPr>
                <a:t>(</a:t>
              </a:r>
              <a:r>
                <a:rPr b="0" i="1" lang="en-US" sz="900" spc="-1" strike="noStrike">
                  <a:solidFill>
                    <a:srgbClr val="000000"/>
                  </a:solidFill>
                  <a:latin typeface="Times New Roman"/>
                  <a:ea typeface="Arial Unicode MS"/>
                </a:rPr>
                <a:t>Nitrospina</a:t>
              </a: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Arial Unicode MS"/>
                </a:rPr>
                <a:t>-like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1" name="テキスト ボックス 30"/>
            <p:cNvSpPr/>
            <p:nvPr/>
          </p:nvSpPr>
          <p:spPr>
            <a:xfrm>
              <a:off x="946440" y="1446840"/>
              <a:ext cx="959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Arial Unicode MS"/>
                </a:rPr>
                <a:t>Nitrospinae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Arial Unicode MS"/>
                </a:rPr>
                <a:t>(</a:t>
              </a:r>
              <a:r>
                <a:rPr b="0" i="1" lang="en-US" sz="900" spc="-1" strike="noStrike">
                  <a:solidFill>
                    <a:srgbClr val="000000"/>
                  </a:solidFill>
                  <a:latin typeface="Times New Roman"/>
                  <a:ea typeface="Arial Unicode MS"/>
                </a:rPr>
                <a:t>Nitrospina</a:t>
              </a: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Arial Unicode MS"/>
                </a:rPr>
                <a:t>-like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2" name="グラフ 12" descr=""/>
          <p:cNvPicPr/>
          <p:nvPr/>
        </p:nvPicPr>
        <p:blipFill>
          <a:blip r:embed="rId1"/>
          <a:stretch/>
        </p:blipFill>
        <p:spPr>
          <a:xfrm>
            <a:off x="2309760" y="3870360"/>
            <a:ext cx="2086200" cy="1817640"/>
          </a:xfrm>
          <a:prstGeom prst="rect">
            <a:avLst/>
          </a:prstGeom>
          <a:ln w="0">
            <a:noFill/>
          </a:ln>
        </p:spPr>
      </p:pic>
      <p:pic>
        <p:nvPicPr>
          <p:cNvPr id="303" name="グラフ 13" descr=""/>
          <p:cNvPicPr/>
          <p:nvPr/>
        </p:nvPicPr>
        <p:blipFill>
          <a:blip r:embed="rId2"/>
          <a:stretch/>
        </p:blipFill>
        <p:spPr>
          <a:xfrm>
            <a:off x="2309760" y="2243160"/>
            <a:ext cx="3183120" cy="1822320"/>
          </a:xfrm>
          <a:prstGeom prst="rect">
            <a:avLst/>
          </a:prstGeom>
          <a:ln w="0">
            <a:noFill/>
          </a:ln>
        </p:spPr>
      </p:pic>
      <p:sp>
        <p:nvSpPr>
          <p:cNvPr id="304" name="テキスト ボックス 4"/>
          <p:cNvSpPr/>
          <p:nvPr/>
        </p:nvSpPr>
        <p:spPr>
          <a:xfrm>
            <a:off x="457200" y="5869080"/>
            <a:ext cx="59436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8. Phylogenetic composition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gc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A) and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gc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B) sequences obtained from the paired-end metagenomic sequences in 500m and 800 m depths at Sts. 0 and 1 (total 62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gc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82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gc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equences, respectively). The numbers in the pie charts represented the sequence abundances of each phylogenetic lineage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5" name="テキスト ボックス 6"/>
          <p:cNvSpPr/>
          <p:nvPr/>
        </p:nvSpPr>
        <p:spPr>
          <a:xfrm>
            <a:off x="3502800" y="315432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6" name="テキスト ボックス 7"/>
          <p:cNvSpPr/>
          <p:nvPr/>
        </p:nvSpPr>
        <p:spPr>
          <a:xfrm>
            <a:off x="2682000" y="30988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7" name="テキスト ボックス 8"/>
          <p:cNvSpPr/>
          <p:nvPr/>
        </p:nvSpPr>
        <p:spPr>
          <a:xfrm>
            <a:off x="2865600" y="266544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8" name="テキスト ボックス 10"/>
          <p:cNvSpPr/>
          <p:nvPr/>
        </p:nvSpPr>
        <p:spPr>
          <a:xfrm>
            <a:off x="2285640" y="2373480"/>
            <a:ext cx="39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9" name="テキスト ボックス 11"/>
          <p:cNvSpPr/>
          <p:nvPr/>
        </p:nvSpPr>
        <p:spPr>
          <a:xfrm>
            <a:off x="2277000" y="3922560"/>
            <a:ext cx="383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0" name="テキスト ボックス 14"/>
          <p:cNvSpPr/>
          <p:nvPr/>
        </p:nvSpPr>
        <p:spPr>
          <a:xfrm>
            <a:off x="3501360" y="480708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1" name="テキスト ボックス 15"/>
          <p:cNvSpPr/>
          <p:nvPr/>
        </p:nvSpPr>
        <p:spPr>
          <a:xfrm>
            <a:off x="2682000" y="47530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2" name="テキスト ボックス 16"/>
          <p:cNvSpPr/>
          <p:nvPr/>
        </p:nvSpPr>
        <p:spPr>
          <a:xfrm>
            <a:off x="2865600" y="431784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3" name="テキスト ボックス 3"/>
          <p:cNvSpPr/>
          <p:nvPr/>
        </p:nvSpPr>
        <p:spPr>
          <a:xfrm>
            <a:off x="396720" y="7670880"/>
            <a:ext cx="606456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9. Maximum likelihood tree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gc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like sequences detected in the paired-end metagenomes from Sts. 0 (A) and 1 (B). Total 100 and 53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gc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equences at Sts. 0 and 1, respectively. Sequences identified in this study (shown in red) are compared with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gc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homologues described in previous reports (Gilmour et al., 2013; Gionfriddo et al., 2016; Gilmour et al., 2018; Christensen et al., 2019; Jones et al., 2019). Bootstrap values with consensus based on 100 replicates are shown. National Center for Biotechnology Information accession numbers or Integrated Microbial Genomes predicted gene numbers are provided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14" name="グループ化 6"/>
          <p:cNvGrpSpPr/>
          <p:nvPr/>
        </p:nvGrpSpPr>
        <p:grpSpPr>
          <a:xfrm>
            <a:off x="1414440" y="360360"/>
            <a:ext cx="4678560" cy="7147080"/>
            <a:chOff x="1414440" y="360360"/>
            <a:chExt cx="4678560" cy="7147080"/>
          </a:xfrm>
        </p:grpSpPr>
        <p:pic>
          <p:nvPicPr>
            <p:cNvPr id="315" name="図 18" descr=""/>
            <p:cNvPicPr/>
            <p:nvPr/>
          </p:nvPicPr>
          <p:blipFill>
            <a:blip r:embed="rId1"/>
            <a:stretch/>
          </p:blipFill>
          <p:spPr>
            <a:xfrm>
              <a:off x="1414440" y="4146480"/>
              <a:ext cx="3572280" cy="3360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16" name="図 4" descr=""/>
            <p:cNvPicPr/>
            <p:nvPr/>
          </p:nvPicPr>
          <p:blipFill>
            <a:blip r:embed="rId2"/>
            <a:stretch/>
          </p:blipFill>
          <p:spPr>
            <a:xfrm>
              <a:off x="1439280" y="493920"/>
              <a:ext cx="3420000" cy="3543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17" name="テキスト ボックス 13"/>
            <p:cNvSpPr/>
            <p:nvPr/>
          </p:nvSpPr>
          <p:spPr>
            <a:xfrm>
              <a:off x="4370400" y="761400"/>
              <a:ext cx="750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Unknown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8" name="円弧 14"/>
            <p:cNvSpPr/>
            <p:nvPr/>
          </p:nvSpPr>
          <p:spPr>
            <a:xfrm>
              <a:off x="1552320" y="483840"/>
              <a:ext cx="3367440" cy="3289320"/>
            </a:xfrm>
            <a:custGeom>
              <a:avLst/>
              <a:gdLst/>
              <a:ahLst/>
              <a:rect l="l" t="t" r="r" b="b"/>
              <a:pathLst>
                <a:path stroke="0" w="3367261" h="3289595">
                  <a:moveTo>
                    <a:pt x="1677828" y="10"/>
                  </a:moveTo>
                  <a:cubicBezTo>
                    <a:pt x="2440118" y="-2556"/>
                    <a:pt x="3109063" y="495561"/>
                    <a:pt x="3308574" y="1214314"/>
                  </a:cubicBezTo>
                  <a:lnTo>
                    <a:pt x="1683631" y="1644798"/>
                  </a:lnTo>
                  <a:cubicBezTo>
                    <a:pt x="1681697" y="1096535"/>
                    <a:pt x="1679762" y="548273"/>
                    <a:pt x="1677828" y="10"/>
                  </a:cubicBezTo>
                  <a:close/>
                </a:path>
                <a:path fill="none" w="3367261" h="3289595">
                  <a:moveTo>
                    <a:pt x="1677828" y="10"/>
                  </a:moveTo>
                  <a:cubicBezTo>
                    <a:pt x="2440118" y="-2556"/>
                    <a:pt x="3109063" y="495561"/>
                    <a:pt x="3308574" y="1214314"/>
                  </a:cubicBezTo>
                </a:path>
              </a:pathLst>
            </a:cu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9" name="円弧 17"/>
            <p:cNvSpPr/>
            <p:nvPr/>
          </p:nvSpPr>
          <p:spPr>
            <a:xfrm>
              <a:off x="1552320" y="483840"/>
              <a:ext cx="3367440" cy="3289320"/>
            </a:xfrm>
            <a:custGeom>
              <a:avLst/>
              <a:gdLst/>
              <a:ahLst/>
              <a:rect l="l" t="t" r="r" b="b"/>
              <a:pathLst>
                <a:path stroke="0" w="3367261" h="3289595">
                  <a:moveTo>
                    <a:pt x="3327163" y="1287966"/>
                  </a:moveTo>
                  <a:cubicBezTo>
                    <a:pt x="3479595" y="1958040"/>
                    <a:pt x="3190052" y="2650134"/>
                    <a:pt x="2600845" y="3024086"/>
                  </a:cubicBezTo>
                  <a:lnTo>
                    <a:pt x="1683631" y="1644798"/>
                  </a:lnTo>
                  <a:lnTo>
                    <a:pt x="3327163" y="1287966"/>
                  </a:lnTo>
                  <a:close/>
                </a:path>
                <a:path fill="none" w="3367261" h="3289595">
                  <a:moveTo>
                    <a:pt x="3327163" y="1287966"/>
                  </a:moveTo>
                  <a:cubicBezTo>
                    <a:pt x="3479595" y="1958040"/>
                    <a:pt x="3190052" y="2650134"/>
                    <a:pt x="2600845" y="3024086"/>
                  </a:cubicBezTo>
                </a:path>
              </a:pathLst>
            </a:cu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0" name="円弧 23"/>
            <p:cNvSpPr/>
            <p:nvPr/>
          </p:nvSpPr>
          <p:spPr>
            <a:xfrm>
              <a:off x="1535040" y="4168800"/>
              <a:ext cx="3365640" cy="3287880"/>
            </a:xfrm>
            <a:custGeom>
              <a:avLst/>
              <a:gdLst/>
              <a:ahLst/>
              <a:rect l="l" t="t" r="r" b="b"/>
              <a:pathLst>
                <a:path stroke="0" w="3365673" h="3288008">
                  <a:moveTo>
                    <a:pt x="1713608" y="275"/>
                  </a:moveTo>
                  <a:cubicBezTo>
                    <a:pt x="2445901" y="13359"/>
                    <a:pt x="3085440" y="487648"/>
                    <a:pt x="3295189" y="1173194"/>
                  </a:cubicBezTo>
                  <a:lnTo>
                    <a:pt x="1682837" y="1644004"/>
                  </a:lnTo>
                  <a:lnTo>
                    <a:pt x="1713608" y="275"/>
                  </a:lnTo>
                  <a:close/>
                </a:path>
                <a:path fill="none" w="3365673" h="3288008">
                  <a:moveTo>
                    <a:pt x="1713608" y="275"/>
                  </a:moveTo>
                  <a:cubicBezTo>
                    <a:pt x="2445901" y="13359"/>
                    <a:pt x="3085440" y="487648"/>
                    <a:pt x="3295189" y="1173194"/>
                  </a:cubicBezTo>
                </a:path>
              </a:pathLst>
            </a:cu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1" name="円弧 26"/>
            <p:cNvSpPr/>
            <p:nvPr/>
          </p:nvSpPr>
          <p:spPr>
            <a:xfrm>
              <a:off x="1539720" y="4183200"/>
              <a:ext cx="3365640" cy="3287880"/>
            </a:xfrm>
            <a:custGeom>
              <a:avLst/>
              <a:gdLst/>
              <a:ahLst/>
              <a:rect l="l" t="t" r="r" b="b"/>
              <a:pathLst>
                <a:path stroke="0" w="3365673" h="3288007">
                  <a:moveTo>
                    <a:pt x="3350380" y="1865140"/>
                  </a:moveTo>
                  <a:cubicBezTo>
                    <a:pt x="3336626" y="1964127"/>
                    <a:pt x="3313665" y="2061684"/>
                    <a:pt x="3281782" y="2156599"/>
                  </a:cubicBezTo>
                  <a:lnTo>
                    <a:pt x="1682837" y="1644004"/>
                  </a:lnTo>
                  <a:lnTo>
                    <a:pt x="3350380" y="1865140"/>
                  </a:lnTo>
                  <a:close/>
                </a:path>
                <a:path fill="none" w="3365673" h="3288007">
                  <a:moveTo>
                    <a:pt x="3350380" y="1865140"/>
                  </a:moveTo>
                  <a:cubicBezTo>
                    <a:pt x="3336626" y="1964127"/>
                    <a:pt x="3313665" y="2061684"/>
                    <a:pt x="3281782" y="2156599"/>
                  </a:cubicBezTo>
                </a:path>
              </a:pathLst>
            </a:cu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2" name="円弧 25"/>
            <p:cNvSpPr/>
            <p:nvPr/>
          </p:nvSpPr>
          <p:spPr>
            <a:xfrm>
              <a:off x="1552320" y="482400"/>
              <a:ext cx="3367440" cy="3289320"/>
            </a:xfrm>
            <a:custGeom>
              <a:avLst/>
              <a:gdLst/>
              <a:ahLst/>
              <a:rect l="l" t="t" r="r" b="b"/>
              <a:pathLst>
                <a:path stroke="0" w="3367261" h="3289595">
                  <a:moveTo>
                    <a:pt x="2405313" y="3130827"/>
                  </a:moveTo>
                  <a:cubicBezTo>
                    <a:pt x="2331522" y="3165029"/>
                    <a:pt x="2255281" y="3193941"/>
                    <a:pt x="2177194" y="3217332"/>
                  </a:cubicBezTo>
                  <a:lnTo>
                    <a:pt x="1683631" y="1644798"/>
                  </a:lnTo>
                  <a:lnTo>
                    <a:pt x="2405313" y="3130827"/>
                  </a:lnTo>
                  <a:close/>
                </a:path>
                <a:path fill="none" w="3367261" h="3289595">
                  <a:moveTo>
                    <a:pt x="2405313" y="3130827"/>
                  </a:moveTo>
                  <a:cubicBezTo>
                    <a:pt x="2331522" y="3165029"/>
                    <a:pt x="2255281" y="3193941"/>
                    <a:pt x="2177194" y="3217332"/>
                  </a:cubicBezTo>
                </a:path>
              </a:pathLst>
            </a:cu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3" name="円弧 28"/>
            <p:cNvSpPr/>
            <p:nvPr/>
          </p:nvSpPr>
          <p:spPr>
            <a:xfrm>
              <a:off x="1535040" y="4165560"/>
              <a:ext cx="3365640" cy="3289320"/>
            </a:xfrm>
            <a:custGeom>
              <a:avLst/>
              <a:gdLst/>
              <a:ahLst/>
              <a:rect l="l" t="t" r="r" b="b"/>
              <a:pathLst>
                <a:path stroke="0" w="3365673" h="3289595">
                  <a:moveTo>
                    <a:pt x="3309039" y="1221680"/>
                  </a:moveTo>
                  <a:cubicBezTo>
                    <a:pt x="3354327" y="1387959"/>
                    <a:pt x="3372639" y="1560153"/>
                    <a:pt x="3363307" y="1731981"/>
                  </a:cubicBezTo>
                  <a:lnTo>
                    <a:pt x="1682837" y="1644798"/>
                  </a:lnTo>
                  <a:lnTo>
                    <a:pt x="3309039" y="1221680"/>
                  </a:lnTo>
                  <a:close/>
                </a:path>
                <a:path fill="none" w="3365673" h="3289595">
                  <a:moveTo>
                    <a:pt x="3309039" y="1221680"/>
                  </a:moveTo>
                  <a:cubicBezTo>
                    <a:pt x="3354327" y="1387959"/>
                    <a:pt x="3372639" y="1560153"/>
                    <a:pt x="3363307" y="1731981"/>
                  </a:cubicBezTo>
                </a:path>
              </a:pathLst>
            </a:cu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4" name="テキスト ボックス 29"/>
            <p:cNvSpPr/>
            <p:nvPr/>
          </p:nvSpPr>
          <p:spPr>
            <a:xfrm>
              <a:off x="4865760" y="5500800"/>
              <a:ext cx="750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Unknown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5" name="テキスト ボックス 20"/>
            <p:cNvSpPr/>
            <p:nvPr/>
          </p:nvSpPr>
          <p:spPr>
            <a:xfrm>
              <a:off x="4374000" y="4321080"/>
              <a:ext cx="959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Arial Unicode MS"/>
                </a:rPr>
                <a:t>Nitrospinae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Arial Unicode MS"/>
                </a:rPr>
                <a:t>(</a:t>
              </a:r>
              <a:r>
                <a:rPr b="0" i="1" lang="en-US" sz="900" spc="-1" strike="noStrike">
                  <a:solidFill>
                    <a:srgbClr val="000000"/>
                  </a:solidFill>
                  <a:latin typeface="Times New Roman"/>
                  <a:ea typeface="Arial Unicode MS"/>
                </a:rPr>
                <a:t>Nitrospina</a:t>
              </a: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Arial Unicode MS"/>
                </a:rPr>
                <a:t>-like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6" name="テキスト ボックス 21"/>
            <p:cNvSpPr/>
            <p:nvPr/>
          </p:nvSpPr>
          <p:spPr>
            <a:xfrm>
              <a:off x="4849200" y="2548440"/>
              <a:ext cx="959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Arial Unicode MS"/>
                </a:rPr>
                <a:t>Nitrospinae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Arial Unicode MS"/>
                </a:rPr>
                <a:t>(</a:t>
              </a:r>
              <a:r>
                <a:rPr b="0" i="1" lang="en-US" sz="900" spc="-1" strike="noStrike">
                  <a:solidFill>
                    <a:srgbClr val="000000"/>
                  </a:solidFill>
                  <a:latin typeface="Times New Roman"/>
                  <a:ea typeface="Arial Unicode MS"/>
                </a:rPr>
                <a:t>Nitrospina</a:t>
              </a: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Arial Unicode MS"/>
                </a:rPr>
                <a:t>-like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7" name="テキスト ボックス 22"/>
            <p:cNvSpPr/>
            <p:nvPr/>
          </p:nvSpPr>
          <p:spPr>
            <a:xfrm>
              <a:off x="4848840" y="6091200"/>
              <a:ext cx="1244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Arial Unicode MS"/>
                </a:rPr>
                <a:t>Deltaproteobacteria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Arial Unicode MS"/>
                </a:rPr>
                <a:t>(</a:t>
              </a:r>
              <a:r>
                <a:rPr b="0" i="1" lang="en-US" sz="900" spc="-1" strike="noStrike">
                  <a:solidFill>
                    <a:srgbClr val="000000"/>
                  </a:solidFill>
                  <a:latin typeface="Times New Roman"/>
                  <a:ea typeface="Arial Unicode MS"/>
                </a:rPr>
                <a:t>Syntrophus</a:t>
              </a: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Arial Unicode MS"/>
                </a:rPr>
                <a:t>-like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8" name="テキスト ボックス 30"/>
            <p:cNvSpPr/>
            <p:nvPr/>
          </p:nvSpPr>
          <p:spPr>
            <a:xfrm>
              <a:off x="3776400" y="3672000"/>
              <a:ext cx="1244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Arial Unicode MS"/>
                </a:rPr>
                <a:t>Deltaproteobacteria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Arial Unicode MS"/>
                </a:rPr>
                <a:t>(</a:t>
              </a:r>
              <a:r>
                <a:rPr b="0" i="1" lang="en-US" sz="900" spc="-1" strike="noStrike">
                  <a:solidFill>
                    <a:srgbClr val="000000"/>
                  </a:solidFill>
                  <a:latin typeface="Times New Roman"/>
                  <a:ea typeface="Arial Unicode MS"/>
                </a:rPr>
                <a:t>Syntrophus</a:t>
              </a: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Arial Unicode MS"/>
                </a:rPr>
                <a:t>-like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9" name="テキスト ボックス 33"/>
            <p:cNvSpPr/>
            <p:nvPr/>
          </p:nvSpPr>
          <p:spPr>
            <a:xfrm>
              <a:off x="1797120" y="360360"/>
              <a:ext cx="3758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A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0" name="テキスト ボックス 34"/>
            <p:cNvSpPr/>
            <p:nvPr/>
          </p:nvSpPr>
          <p:spPr>
            <a:xfrm>
              <a:off x="1801440" y="4289040"/>
              <a:ext cx="368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B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78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3-13T08:27:18Z</dcterms:created>
  <dc:creator>tada</dc:creator>
  <dc:description/>
  <dc:language>en-US</dc:language>
  <cp:lastModifiedBy>多田 雄哉</cp:lastModifiedBy>
  <cp:lastPrinted>2020-05-23T11:31:52Z</cp:lastPrinted>
  <dcterms:modified xsi:type="dcterms:W3CDTF">2020-05-23T11:35:53Z</dcterms:modified>
  <cp:revision>464</cp:revision>
  <dc:subject/>
  <dc:title>PowerPoint プレゼンテーション</dc:title>
</cp:coreProperties>
</file>